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4"/>
  </p:sldMasterIdLst>
  <p:notesMasterIdLst>
    <p:notesMasterId r:id="rId10"/>
  </p:notesMasterIdLst>
  <p:sldIdLst>
    <p:sldId id="907" r:id="rId5"/>
    <p:sldId id="909" r:id="rId6"/>
    <p:sldId id="910" r:id="rId7"/>
    <p:sldId id="908" r:id="rId8"/>
    <p:sldId id="911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2912">
          <p15:clr>
            <a:srgbClr val="A4A3A4"/>
          </p15:clr>
        </p15:guide>
        <p15:guide id="4" pos="21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2A1E"/>
    <a:srgbClr val="000080"/>
    <a:srgbClr val="A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BC14486-7AA5-46D4-8D7F-CE8376DEAE6D}" v="9" dt="2020-11-19T22:20:59.770"/>
  </p1510:revLst>
</p1510:revInfo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86" autoAdjust="0"/>
    <p:restoredTop sz="93792" autoAdjust="0"/>
  </p:normalViewPr>
  <p:slideViewPr>
    <p:cSldViewPr snapToGrid="0">
      <p:cViewPr>
        <p:scale>
          <a:sx n="100" d="100"/>
          <a:sy n="100" d="100"/>
        </p:scale>
        <p:origin x="1272" y="48"/>
      </p:cViewPr>
      <p:guideLst>
        <p:guide orient="horz" pos="3120"/>
        <p:guide pos="2160"/>
        <p:guide orient="horz" pos="2912"/>
        <p:guide pos="217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ron Khuzwayo" userId="508b925d-0867-40ec-8808-4146cd359f6b" providerId="ADAL" clId="{750A2444-04C4-4CC6-93F6-5DD3B51A05D5}"/>
    <pc:docChg chg="undo custSel modSld">
      <pc:chgData name="Sharon Khuzwayo" userId="508b925d-0867-40ec-8808-4146cd359f6b" providerId="ADAL" clId="{750A2444-04C4-4CC6-93F6-5DD3B51A05D5}" dt="2020-11-19T06:20:02.878" v="3" actId="6549"/>
      <pc:docMkLst>
        <pc:docMk/>
      </pc:docMkLst>
      <pc:sldChg chg="addSp delSp modSp mod">
        <pc:chgData name="Sharon Khuzwayo" userId="508b925d-0867-40ec-8808-4146cd359f6b" providerId="ADAL" clId="{750A2444-04C4-4CC6-93F6-5DD3B51A05D5}" dt="2020-11-19T06:20:02.878" v="3" actId="6549"/>
        <pc:sldMkLst>
          <pc:docMk/>
          <pc:sldMk cId="474877388" sldId="902"/>
        </pc:sldMkLst>
        <pc:spChg chg="add del mod">
          <ac:chgData name="Sharon Khuzwayo" userId="508b925d-0867-40ec-8808-4146cd359f6b" providerId="ADAL" clId="{750A2444-04C4-4CC6-93F6-5DD3B51A05D5}" dt="2020-11-19T06:20:02.878" v="3" actId="6549"/>
          <ac:spMkLst>
            <pc:docMk/>
            <pc:sldMk cId="474877388" sldId="902"/>
            <ac:spMk id="39" creationId="{F9ECAF79-7895-4C88-B11C-FBB07ABBDBAB}"/>
          </ac:spMkLst>
        </pc:spChg>
      </pc:sldChg>
    </pc:docChg>
  </pc:docChgLst>
  <pc:docChgLst>
    <pc:chgData name="Sharon Khuzwayo" userId="508b925d-0867-40ec-8808-4146cd359f6b" providerId="ADAL" clId="{9BC14486-7AA5-46D4-8D7F-CE8376DEAE6D}"/>
    <pc:docChg chg="undo custSel addSld delSld modSld delMainMaster">
      <pc:chgData name="Sharon Khuzwayo" userId="508b925d-0867-40ec-8808-4146cd359f6b" providerId="ADAL" clId="{9BC14486-7AA5-46D4-8D7F-CE8376DEAE6D}" dt="2020-11-19T22:25:20.733" v="514" actId="1037"/>
      <pc:docMkLst>
        <pc:docMk/>
      </pc:docMkLst>
      <pc:sldChg chg="del">
        <pc:chgData name="Sharon Khuzwayo" userId="508b925d-0867-40ec-8808-4146cd359f6b" providerId="ADAL" clId="{9BC14486-7AA5-46D4-8D7F-CE8376DEAE6D}" dt="2020-11-19T11:58:56.354" v="0" actId="47"/>
        <pc:sldMkLst>
          <pc:docMk/>
          <pc:sldMk cId="741587313" sldId="816"/>
        </pc:sldMkLst>
      </pc:sldChg>
      <pc:sldChg chg="del">
        <pc:chgData name="Sharon Khuzwayo" userId="508b925d-0867-40ec-8808-4146cd359f6b" providerId="ADAL" clId="{9BC14486-7AA5-46D4-8D7F-CE8376DEAE6D}" dt="2020-11-19T11:58:56.354" v="0" actId="47"/>
        <pc:sldMkLst>
          <pc:docMk/>
          <pc:sldMk cId="474877388" sldId="902"/>
        </pc:sldMkLst>
      </pc:sldChg>
      <pc:sldChg chg="del">
        <pc:chgData name="Sharon Khuzwayo" userId="508b925d-0867-40ec-8808-4146cd359f6b" providerId="ADAL" clId="{9BC14486-7AA5-46D4-8D7F-CE8376DEAE6D}" dt="2020-11-19T11:58:56.354" v="0" actId="47"/>
        <pc:sldMkLst>
          <pc:docMk/>
          <pc:sldMk cId="3006089881" sldId="903"/>
        </pc:sldMkLst>
      </pc:sldChg>
      <pc:sldChg chg="del">
        <pc:chgData name="Sharon Khuzwayo" userId="508b925d-0867-40ec-8808-4146cd359f6b" providerId="ADAL" clId="{9BC14486-7AA5-46D4-8D7F-CE8376DEAE6D}" dt="2020-11-19T11:58:56.354" v="0" actId="47"/>
        <pc:sldMkLst>
          <pc:docMk/>
          <pc:sldMk cId="452526124" sldId="905"/>
        </pc:sldMkLst>
      </pc:sldChg>
      <pc:sldChg chg="addSp delSp modSp mod">
        <pc:chgData name="Sharon Khuzwayo" userId="508b925d-0867-40ec-8808-4146cd359f6b" providerId="ADAL" clId="{9BC14486-7AA5-46D4-8D7F-CE8376DEAE6D}" dt="2020-11-19T22:25:20.733" v="514" actId="1037"/>
        <pc:sldMkLst>
          <pc:docMk/>
          <pc:sldMk cId="229617064" sldId="907"/>
        </pc:sldMkLst>
        <pc:spChg chg="mod">
          <ac:chgData name="Sharon Khuzwayo" userId="508b925d-0867-40ec-8808-4146cd359f6b" providerId="ADAL" clId="{9BC14486-7AA5-46D4-8D7F-CE8376DEAE6D}" dt="2020-11-19T22:12:44.928" v="295" actId="1036"/>
          <ac:spMkLst>
            <pc:docMk/>
            <pc:sldMk cId="229617064" sldId="907"/>
            <ac:spMk id="2" creationId="{92385024-C22B-4DD4-842F-89AE709F4DDC}"/>
          </ac:spMkLst>
        </pc:spChg>
        <pc:spChg chg="del">
          <ac:chgData name="Sharon Khuzwayo" userId="508b925d-0867-40ec-8808-4146cd359f6b" providerId="ADAL" clId="{9BC14486-7AA5-46D4-8D7F-CE8376DEAE6D}" dt="2020-11-19T11:59:04.810" v="3" actId="478"/>
          <ac:spMkLst>
            <pc:docMk/>
            <pc:sldMk cId="229617064" sldId="907"/>
            <ac:spMk id="3" creationId="{0911E71B-B185-4DB7-BCBF-0ED4364F7251}"/>
          </ac:spMkLst>
        </pc:spChg>
        <pc:spChg chg="del">
          <ac:chgData name="Sharon Khuzwayo" userId="508b925d-0867-40ec-8808-4146cd359f6b" providerId="ADAL" clId="{9BC14486-7AA5-46D4-8D7F-CE8376DEAE6D}" dt="2020-11-19T11:59:04.810" v="3" actId="478"/>
          <ac:spMkLst>
            <pc:docMk/>
            <pc:sldMk cId="229617064" sldId="907"/>
            <ac:spMk id="5" creationId="{F7CB35E9-F7F7-4F91-8376-AFFE0C63D863}"/>
          </ac:spMkLst>
        </pc:spChg>
        <pc:spChg chg="del">
          <ac:chgData name="Sharon Khuzwayo" userId="508b925d-0867-40ec-8808-4146cd359f6b" providerId="ADAL" clId="{9BC14486-7AA5-46D4-8D7F-CE8376DEAE6D}" dt="2020-11-19T11:59:08.588" v="4" actId="478"/>
          <ac:spMkLst>
            <pc:docMk/>
            <pc:sldMk cId="229617064" sldId="907"/>
            <ac:spMk id="6" creationId="{B67C62CE-E81B-4578-A4E5-F6687A125F84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12" creationId="{0E1530A5-0057-4BE6-A8B4-A0F2A0C0459E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14" creationId="{7D40BAB3-B111-4894-8F99-3A2B91398F57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15" creationId="{D28C82F7-A3EE-4685-AA7B-C252E337C452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16" creationId="{291240AC-7CA6-4DE6-B085-0207F4AAE437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17" creationId="{B48FBD28-4375-4046-BEFD-E8A7AE70D470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23" creationId="{DA8B364E-E56B-4A4D-9CF0-E7E67E9BFF08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24" creationId="{23E7FBEA-D03E-4F1B-BD39-C56354545105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25" creationId="{AA607A4E-6238-4157-A626-CE0C65339AB5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26" creationId="{A43FABB7-0C25-4059-A88F-28849B3AE71E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28" creationId="{35430F0E-3B3A-450C-B619-1602604DE194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35" creationId="{39BEA359-240E-4A76-BC96-DADE74A1D286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36" creationId="{C045564D-C335-40A4-8091-3FAEA32009C2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37" creationId="{B85755AB-ADD5-41D5-BCC5-2664044EC1A5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38" creationId="{74BDB472-111C-4F17-AD75-B4D8B3452AE9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40" creationId="{2E9EAD00-15E9-4D72-8725-C43F056738FF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42" creationId="{60FDD08A-3591-4324-858A-122FD019B910}"/>
          </ac:spMkLst>
        </pc:spChg>
        <pc:spChg chg="mod">
          <ac:chgData name="Sharon Khuzwayo" userId="508b925d-0867-40ec-8808-4146cd359f6b" providerId="ADAL" clId="{9BC14486-7AA5-46D4-8D7F-CE8376DEAE6D}" dt="2020-11-19T22:12:01.262" v="202"/>
          <ac:spMkLst>
            <pc:docMk/>
            <pc:sldMk cId="229617064" sldId="907"/>
            <ac:spMk id="44" creationId="{C40C001C-5738-4025-8BB8-405776BC7253}"/>
          </ac:spMkLst>
        </pc:spChg>
        <pc:spChg chg="del">
          <ac:chgData name="Sharon Khuzwayo" userId="508b925d-0867-40ec-8808-4146cd359f6b" providerId="ADAL" clId="{9BC14486-7AA5-46D4-8D7F-CE8376DEAE6D}" dt="2020-11-19T11:59:04.810" v="3" actId="478"/>
          <ac:spMkLst>
            <pc:docMk/>
            <pc:sldMk cId="229617064" sldId="907"/>
            <ac:spMk id="63" creationId="{FB80E37B-2710-4F50-A2CC-5D2A41DAE825}"/>
          </ac:spMkLst>
        </pc:spChg>
        <pc:spChg chg="del">
          <ac:chgData name="Sharon Khuzwayo" userId="508b925d-0867-40ec-8808-4146cd359f6b" providerId="ADAL" clId="{9BC14486-7AA5-46D4-8D7F-CE8376DEAE6D}" dt="2020-11-19T11:59:04.810" v="3" actId="478"/>
          <ac:spMkLst>
            <pc:docMk/>
            <pc:sldMk cId="229617064" sldId="907"/>
            <ac:spMk id="64" creationId="{7D2344AD-F935-4EF8-AF11-1F0F54F9395E}"/>
          </ac:spMkLst>
        </pc:spChg>
        <pc:spChg chg="del">
          <ac:chgData name="Sharon Khuzwayo" userId="508b925d-0867-40ec-8808-4146cd359f6b" providerId="ADAL" clId="{9BC14486-7AA5-46D4-8D7F-CE8376DEAE6D}" dt="2020-11-19T11:59:08.588" v="4" actId="478"/>
          <ac:spMkLst>
            <pc:docMk/>
            <pc:sldMk cId="229617064" sldId="907"/>
            <ac:spMk id="73" creationId="{01FE7796-1385-4C24-AFAC-12AFE94103C1}"/>
          </ac:spMkLst>
        </pc:spChg>
        <pc:spChg chg="mod">
          <ac:chgData name="Sharon Khuzwayo" userId="508b925d-0867-40ec-8808-4146cd359f6b" providerId="ADAL" clId="{9BC14486-7AA5-46D4-8D7F-CE8376DEAE6D}" dt="2020-11-19T22:25:20.733" v="514" actId="1037"/>
          <ac:spMkLst>
            <pc:docMk/>
            <pc:sldMk cId="229617064" sldId="907"/>
            <ac:spMk id="167" creationId="{A8E1646D-60C7-4ED9-AA2F-71E67001D5A1}"/>
          </ac:spMkLst>
        </pc:spChg>
        <pc:spChg chg="mod">
          <ac:chgData name="Sharon Khuzwayo" userId="508b925d-0867-40ec-8808-4146cd359f6b" providerId="ADAL" clId="{9BC14486-7AA5-46D4-8D7F-CE8376DEAE6D}" dt="2020-11-19T22:25:20.733" v="514" actId="1037"/>
          <ac:spMkLst>
            <pc:docMk/>
            <pc:sldMk cId="229617064" sldId="907"/>
            <ac:spMk id="183" creationId="{0D7B230D-37E4-4C28-A0FD-54889FCF87A4}"/>
          </ac:spMkLst>
        </pc:spChg>
        <pc:spChg chg="mod">
          <ac:chgData name="Sharon Khuzwayo" userId="508b925d-0867-40ec-8808-4146cd359f6b" providerId="ADAL" clId="{9BC14486-7AA5-46D4-8D7F-CE8376DEAE6D}" dt="2020-11-19T22:25:20.733" v="514" actId="1037"/>
          <ac:spMkLst>
            <pc:docMk/>
            <pc:sldMk cId="229617064" sldId="907"/>
            <ac:spMk id="184" creationId="{3C55FDC0-ED78-4714-8D40-0312383C4D0A}"/>
          </ac:spMkLst>
        </pc:spChg>
        <pc:grpChg chg="add mod">
          <ac:chgData name="Sharon Khuzwayo" userId="508b925d-0867-40ec-8808-4146cd359f6b" providerId="ADAL" clId="{9BC14486-7AA5-46D4-8D7F-CE8376DEAE6D}" dt="2020-11-19T22:25:20.733" v="514" actId="1037"/>
          <ac:grpSpMkLst>
            <pc:docMk/>
            <pc:sldMk cId="229617064" sldId="907"/>
            <ac:grpSpMk id="7" creationId="{CB0E65DD-3D06-4945-83B0-4700E202A91C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9" creationId="{5C54A7BF-7D31-4300-87FA-113A7DBE1360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10" creationId="{20D556D4-BCBF-4D14-B233-BB5F90DE4DA7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11" creationId="{F5905B0C-DBC7-452A-BB1A-769EB9AF737C}"/>
          </ac:grpSpMkLst>
        </pc:grpChg>
        <pc:grpChg chg="add mod">
          <ac:chgData name="Sharon Khuzwayo" userId="508b925d-0867-40ec-8808-4146cd359f6b" providerId="ADAL" clId="{9BC14486-7AA5-46D4-8D7F-CE8376DEAE6D}" dt="2020-11-19T22:25:20.733" v="514" actId="1037"/>
          <ac:grpSpMkLst>
            <pc:docMk/>
            <pc:sldMk cId="229617064" sldId="907"/>
            <ac:grpSpMk id="19" creationId="{0EC5B389-4873-47E3-BB00-CBDE03856082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21" creationId="{33209990-4171-479A-9310-BC44E667CCFD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22" creationId="{ED81A028-D0DD-455A-945D-7685F1C3EB13}"/>
          </ac:grpSpMkLst>
        </pc:grpChg>
        <pc:grpChg chg="add mod">
          <ac:chgData name="Sharon Khuzwayo" userId="508b925d-0867-40ec-8808-4146cd359f6b" providerId="ADAL" clId="{9BC14486-7AA5-46D4-8D7F-CE8376DEAE6D}" dt="2020-11-19T22:25:20.733" v="514" actId="1037"/>
          <ac:grpSpMkLst>
            <pc:docMk/>
            <pc:sldMk cId="229617064" sldId="907"/>
            <ac:grpSpMk id="29" creationId="{512AF552-7AFA-4724-8256-7D52A495B09F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31" creationId="{9202E996-5BB8-4284-97E1-2BE5240B6C54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32" creationId="{DF8C09B6-E6D3-4C43-BB99-73EDB4A04745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33" creationId="{FF8AD133-7D10-4391-BE5A-0EB96EBF4063}"/>
          </ac:grpSpMkLst>
        </pc:grpChg>
        <pc:grpChg chg="mod">
          <ac:chgData name="Sharon Khuzwayo" userId="508b925d-0867-40ec-8808-4146cd359f6b" providerId="ADAL" clId="{9BC14486-7AA5-46D4-8D7F-CE8376DEAE6D}" dt="2020-11-19T22:12:01.262" v="202"/>
          <ac:grpSpMkLst>
            <pc:docMk/>
            <pc:sldMk cId="229617064" sldId="907"/>
            <ac:grpSpMk id="34" creationId="{05736C24-A75A-4DF4-A881-87D15EE594A8}"/>
          </ac:grpSpMkLst>
        </pc:grpChg>
        <pc:graphicFrameChg chg="mod">
          <ac:chgData name="Sharon Khuzwayo" userId="508b925d-0867-40ec-8808-4146cd359f6b" providerId="ADAL" clId="{9BC14486-7AA5-46D4-8D7F-CE8376DEAE6D}" dt="2020-11-19T22:12:01.262" v="202"/>
          <ac:graphicFrameMkLst>
            <pc:docMk/>
            <pc:sldMk cId="229617064" sldId="907"/>
            <ac:graphicFrameMk id="8" creationId="{51C28E4E-7E2B-4DAE-9E4C-8F900D664BE6}"/>
          </ac:graphicFrameMkLst>
        </pc:graphicFrameChg>
        <pc:graphicFrameChg chg="mod">
          <ac:chgData name="Sharon Khuzwayo" userId="508b925d-0867-40ec-8808-4146cd359f6b" providerId="ADAL" clId="{9BC14486-7AA5-46D4-8D7F-CE8376DEAE6D}" dt="2020-11-19T22:12:01.262" v="202"/>
          <ac:graphicFrameMkLst>
            <pc:docMk/>
            <pc:sldMk cId="229617064" sldId="907"/>
            <ac:graphicFrameMk id="20" creationId="{2D31D465-BEDB-477B-8A0E-0261724BD8A9}"/>
          </ac:graphicFrameMkLst>
        </pc:graphicFrameChg>
        <pc:graphicFrameChg chg="mod">
          <ac:chgData name="Sharon Khuzwayo" userId="508b925d-0867-40ec-8808-4146cd359f6b" providerId="ADAL" clId="{9BC14486-7AA5-46D4-8D7F-CE8376DEAE6D}" dt="2020-11-19T22:12:01.262" v="202"/>
          <ac:graphicFrameMkLst>
            <pc:docMk/>
            <pc:sldMk cId="229617064" sldId="907"/>
            <ac:graphicFrameMk id="30" creationId="{8FD579FD-99AF-457D-A2A1-D1B06941B4D6}"/>
          </ac:graphicFrameMkLst>
        </pc:graphicFrameChg>
        <pc:picChg chg="del">
          <ac:chgData name="Sharon Khuzwayo" userId="508b925d-0867-40ec-8808-4146cd359f6b" providerId="ADAL" clId="{9BC14486-7AA5-46D4-8D7F-CE8376DEAE6D}" dt="2020-11-19T11:59:04.810" v="3" actId="478"/>
          <ac:picMkLst>
            <pc:docMk/>
            <pc:sldMk cId="229617064" sldId="907"/>
            <ac:picMk id="4" creationId="{4286AFC6-FD9B-4C69-BC3B-5E4A739947F1}"/>
          </ac:picMkLst>
        </pc:picChg>
        <pc:picChg chg="del">
          <ac:chgData name="Sharon Khuzwayo" userId="508b925d-0867-40ec-8808-4146cd359f6b" providerId="ADAL" clId="{9BC14486-7AA5-46D4-8D7F-CE8376DEAE6D}" dt="2020-11-19T11:59:04.810" v="3" actId="478"/>
          <ac:picMkLst>
            <pc:docMk/>
            <pc:sldMk cId="229617064" sldId="907"/>
            <ac:picMk id="7" creationId="{FC77F16E-5F1A-4BDC-98C8-0A7F02221C9E}"/>
          </ac:picMkLst>
        </pc:picChg>
        <pc:picChg chg="del">
          <ac:chgData name="Sharon Khuzwayo" userId="508b925d-0867-40ec-8808-4146cd359f6b" providerId="ADAL" clId="{9BC14486-7AA5-46D4-8D7F-CE8376DEAE6D}" dt="2020-11-19T22:12:10.704" v="204" actId="478"/>
          <ac:picMkLst>
            <pc:docMk/>
            <pc:sldMk cId="229617064" sldId="907"/>
            <ac:picMk id="13" creationId="{1C8EAEFF-C3A1-4FEE-8775-E622F577E235}"/>
          </ac:picMkLst>
        </pc:picChg>
        <pc:picChg chg="del">
          <ac:chgData name="Sharon Khuzwayo" userId="508b925d-0867-40ec-8808-4146cd359f6b" providerId="ADAL" clId="{9BC14486-7AA5-46D4-8D7F-CE8376DEAE6D}" dt="2020-11-19T11:59:04.810" v="3" actId="478"/>
          <ac:picMkLst>
            <pc:docMk/>
            <pc:sldMk cId="229617064" sldId="907"/>
            <ac:picMk id="17" creationId="{AADC6471-4D67-4FB1-93D6-46BDD89E28BD}"/>
          </ac:picMkLst>
        </pc:picChg>
        <pc:cxnChg chg="mod">
          <ac:chgData name="Sharon Khuzwayo" userId="508b925d-0867-40ec-8808-4146cd359f6b" providerId="ADAL" clId="{9BC14486-7AA5-46D4-8D7F-CE8376DEAE6D}" dt="2020-11-19T22:12:01.262" v="202"/>
          <ac:cxnSpMkLst>
            <pc:docMk/>
            <pc:sldMk cId="229617064" sldId="907"/>
            <ac:cxnSpMk id="18" creationId="{5BF29CF1-9F47-4CCA-8D39-DF3F1D7533E3}"/>
          </ac:cxnSpMkLst>
        </pc:cxnChg>
        <pc:cxnChg chg="mod">
          <ac:chgData name="Sharon Khuzwayo" userId="508b925d-0867-40ec-8808-4146cd359f6b" providerId="ADAL" clId="{9BC14486-7AA5-46D4-8D7F-CE8376DEAE6D}" dt="2020-11-19T22:12:01.262" v="202"/>
          <ac:cxnSpMkLst>
            <pc:docMk/>
            <pc:sldMk cId="229617064" sldId="907"/>
            <ac:cxnSpMk id="27" creationId="{141B033B-A7D4-4BA7-BFF9-FB46E851B2C2}"/>
          </ac:cxnSpMkLst>
        </pc:cxnChg>
        <pc:cxnChg chg="mod">
          <ac:chgData name="Sharon Khuzwayo" userId="508b925d-0867-40ec-8808-4146cd359f6b" providerId="ADAL" clId="{9BC14486-7AA5-46D4-8D7F-CE8376DEAE6D}" dt="2020-11-19T22:12:01.262" v="202"/>
          <ac:cxnSpMkLst>
            <pc:docMk/>
            <pc:sldMk cId="229617064" sldId="907"/>
            <ac:cxnSpMk id="39" creationId="{BA3CA7E3-3B3C-4F88-9817-C3E76D1C1AA8}"/>
          </ac:cxnSpMkLst>
        </pc:cxnChg>
        <pc:cxnChg chg="mod">
          <ac:chgData name="Sharon Khuzwayo" userId="508b925d-0867-40ec-8808-4146cd359f6b" providerId="ADAL" clId="{9BC14486-7AA5-46D4-8D7F-CE8376DEAE6D}" dt="2020-11-19T22:12:01.262" v="202"/>
          <ac:cxnSpMkLst>
            <pc:docMk/>
            <pc:sldMk cId="229617064" sldId="907"/>
            <ac:cxnSpMk id="41" creationId="{01F67C57-1E29-49F6-8E13-D4EE6DF178CA}"/>
          </ac:cxnSpMkLst>
        </pc:cxnChg>
        <pc:cxnChg chg="mod">
          <ac:chgData name="Sharon Khuzwayo" userId="508b925d-0867-40ec-8808-4146cd359f6b" providerId="ADAL" clId="{9BC14486-7AA5-46D4-8D7F-CE8376DEAE6D}" dt="2020-11-19T22:12:01.262" v="202"/>
          <ac:cxnSpMkLst>
            <pc:docMk/>
            <pc:sldMk cId="229617064" sldId="907"/>
            <ac:cxnSpMk id="43" creationId="{A5C8E7E8-1494-49AC-B425-505C762298C7}"/>
          </ac:cxnSpMkLst>
        </pc:cxnChg>
      </pc:sldChg>
      <pc:sldChg chg="delSp modSp mod">
        <pc:chgData name="Sharon Khuzwayo" userId="508b925d-0867-40ec-8808-4146cd359f6b" providerId="ADAL" clId="{9BC14486-7AA5-46D4-8D7F-CE8376DEAE6D}" dt="2020-11-19T22:24:33.210" v="501" actId="1076"/>
        <pc:sldMkLst>
          <pc:docMk/>
          <pc:sldMk cId="2812554566" sldId="908"/>
        </pc:sldMkLst>
        <pc:spChg chg="mod">
          <ac:chgData name="Sharon Khuzwayo" userId="508b925d-0867-40ec-8808-4146cd359f6b" providerId="ADAL" clId="{9BC14486-7AA5-46D4-8D7F-CE8376DEAE6D}" dt="2020-11-19T22:24:18.429" v="499" actId="1036"/>
          <ac:spMkLst>
            <pc:docMk/>
            <pc:sldMk cId="2812554566" sldId="908"/>
            <ac:spMk id="5" creationId="{6BB6013E-385B-4387-8B1C-17B90E00441B}"/>
          </ac:spMkLst>
        </pc:spChg>
        <pc:spChg chg="del">
          <ac:chgData name="Sharon Khuzwayo" userId="508b925d-0867-40ec-8808-4146cd359f6b" providerId="ADAL" clId="{9BC14486-7AA5-46D4-8D7F-CE8376DEAE6D}" dt="2020-11-19T12:00:04.385" v="124" actId="478"/>
          <ac:spMkLst>
            <pc:docMk/>
            <pc:sldMk cId="2812554566" sldId="908"/>
            <ac:spMk id="11" creationId="{05E72D94-4F57-4C5C-B3B9-B86D2106CD76}"/>
          </ac:spMkLst>
        </pc:spChg>
        <pc:grpChg chg="mod">
          <ac:chgData name="Sharon Khuzwayo" userId="508b925d-0867-40ec-8808-4146cd359f6b" providerId="ADAL" clId="{9BC14486-7AA5-46D4-8D7F-CE8376DEAE6D}" dt="2020-11-19T22:24:33.210" v="501" actId="1076"/>
          <ac:grpSpMkLst>
            <pc:docMk/>
            <pc:sldMk cId="2812554566" sldId="908"/>
            <ac:grpSpMk id="22" creationId="{19C20ED8-E0C1-4E3E-B24A-14ABE210D99B}"/>
          </ac:grpSpMkLst>
        </pc:grpChg>
        <pc:picChg chg="del">
          <ac:chgData name="Sharon Khuzwayo" userId="508b925d-0867-40ec-8808-4146cd359f6b" providerId="ADAL" clId="{9BC14486-7AA5-46D4-8D7F-CE8376DEAE6D}" dt="2020-11-19T12:00:04.385" v="124" actId="478"/>
          <ac:picMkLst>
            <pc:docMk/>
            <pc:sldMk cId="2812554566" sldId="908"/>
            <ac:picMk id="3" creationId="{AF57299C-EA18-44FE-8771-549AEED493A9}"/>
          </ac:picMkLst>
        </pc:picChg>
      </pc:sldChg>
      <pc:sldChg chg="addSp delSp modSp add mod">
        <pc:chgData name="Sharon Khuzwayo" userId="508b925d-0867-40ec-8808-4146cd359f6b" providerId="ADAL" clId="{9BC14486-7AA5-46D4-8D7F-CE8376DEAE6D}" dt="2020-11-19T22:17:59.534" v="372" actId="1037"/>
        <pc:sldMkLst>
          <pc:docMk/>
          <pc:sldMk cId="1209583907" sldId="909"/>
        </pc:sldMkLst>
        <pc:spChg chg="del">
          <ac:chgData name="Sharon Khuzwayo" userId="508b925d-0867-40ec-8808-4146cd359f6b" providerId="ADAL" clId="{9BC14486-7AA5-46D4-8D7F-CE8376DEAE6D}" dt="2020-11-19T11:59:21.773" v="7" actId="478"/>
          <ac:spMkLst>
            <pc:docMk/>
            <pc:sldMk cId="1209583907" sldId="909"/>
            <ac:spMk id="2" creationId="{92385024-C22B-4DD4-842F-89AE709F4DDC}"/>
          </ac:spMkLst>
        </pc:spChg>
        <pc:spChg chg="del">
          <ac:chgData name="Sharon Khuzwayo" userId="508b925d-0867-40ec-8808-4146cd359f6b" providerId="ADAL" clId="{9BC14486-7AA5-46D4-8D7F-CE8376DEAE6D}" dt="2020-11-19T11:59:18.626" v="6" actId="478"/>
          <ac:spMkLst>
            <pc:docMk/>
            <pc:sldMk cId="1209583907" sldId="909"/>
            <ac:spMk id="3" creationId="{0911E71B-B185-4DB7-BCBF-0ED4364F7251}"/>
          </ac:spMkLst>
        </pc:spChg>
        <pc:spChg chg="del">
          <ac:chgData name="Sharon Khuzwayo" userId="508b925d-0867-40ec-8808-4146cd359f6b" providerId="ADAL" clId="{9BC14486-7AA5-46D4-8D7F-CE8376DEAE6D}" dt="2020-11-19T11:59:18.626" v="6" actId="478"/>
          <ac:spMkLst>
            <pc:docMk/>
            <pc:sldMk cId="1209583907" sldId="909"/>
            <ac:spMk id="5" creationId="{F7CB35E9-F7F7-4F91-8376-AFFE0C63D863}"/>
          </ac:spMkLst>
        </pc:spChg>
        <pc:spChg chg="del">
          <ac:chgData name="Sharon Khuzwayo" userId="508b925d-0867-40ec-8808-4146cd359f6b" providerId="ADAL" clId="{9BC14486-7AA5-46D4-8D7F-CE8376DEAE6D}" dt="2020-11-19T11:59:15.897" v="5" actId="478"/>
          <ac:spMkLst>
            <pc:docMk/>
            <pc:sldMk cId="1209583907" sldId="909"/>
            <ac:spMk id="6" creationId="{B67C62CE-E81B-4578-A4E5-F6687A125F84}"/>
          </ac:spMkLst>
        </pc:spChg>
        <pc:spChg chg="mod">
          <ac:chgData name="Sharon Khuzwayo" userId="508b925d-0867-40ec-8808-4146cd359f6b" providerId="ADAL" clId="{9BC14486-7AA5-46D4-8D7F-CE8376DEAE6D}" dt="2020-11-19T22:16:39.440" v="327"/>
          <ac:spMkLst>
            <pc:docMk/>
            <pc:sldMk cId="1209583907" sldId="909"/>
            <ac:spMk id="10" creationId="{CD009423-8070-49B2-BFA2-32A1F5483A9C}"/>
          </ac:spMkLst>
        </pc:spChg>
        <pc:spChg chg="mod">
          <ac:chgData name="Sharon Khuzwayo" userId="508b925d-0867-40ec-8808-4146cd359f6b" providerId="ADAL" clId="{9BC14486-7AA5-46D4-8D7F-CE8376DEAE6D}" dt="2020-11-19T22:17:59.534" v="372" actId="1037"/>
          <ac:spMkLst>
            <pc:docMk/>
            <pc:sldMk cId="1209583907" sldId="909"/>
            <ac:spMk id="63" creationId="{FB80E37B-2710-4F50-A2CC-5D2A41DAE825}"/>
          </ac:spMkLst>
        </pc:spChg>
        <pc:spChg chg="mod">
          <ac:chgData name="Sharon Khuzwayo" userId="508b925d-0867-40ec-8808-4146cd359f6b" providerId="ADAL" clId="{9BC14486-7AA5-46D4-8D7F-CE8376DEAE6D}" dt="2020-11-19T11:59:28.828" v="46" actId="1035"/>
          <ac:spMkLst>
            <pc:docMk/>
            <pc:sldMk cId="1209583907" sldId="909"/>
            <ac:spMk id="64" creationId="{7D2344AD-F935-4EF8-AF11-1F0F54F9395E}"/>
          </ac:spMkLst>
        </pc:spChg>
        <pc:spChg chg="mod">
          <ac:chgData name="Sharon Khuzwayo" userId="508b925d-0867-40ec-8808-4146cd359f6b" providerId="ADAL" clId="{9BC14486-7AA5-46D4-8D7F-CE8376DEAE6D}" dt="2020-11-19T22:17:30.611" v="366" actId="1038"/>
          <ac:spMkLst>
            <pc:docMk/>
            <pc:sldMk cId="1209583907" sldId="909"/>
            <ac:spMk id="73" creationId="{01FE7796-1385-4C24-AFAC-12AFE94103C1}"/>
          </ac:spMkLst>
        </pc:spChg>
        <pc:spChg chg="del">
          <ac:chgData name="Sharon Khuzwayo" userId="508b925d-0867-40ec-8808-4146cd359f6b" providerId="ADAL" clId="{9BC14486-7AA5-46D4-8D7F-CE8376DEAE6D}" dt="2020-11-19T11:59:21.773" v="7" actId="478"/>
          <ac:spMkLst>
            <pc:docMk/>
            <pc:sldMk cId="1209583907" sldId="909"/>
            <ac:spMk id="167" creationId="{A8E1646D-60C7-4ED9-AA2F-71E67001D5A1}"/>
          </ac:spMkLst>
        </pc:spChg>
        <pc:spChg chg="del">
          <ac:chgData name="Sharon Khuzwayo" userId="508b925d-0867-40ec-8808-4146cd359f6b" providerId="ADAL" clId="{9BC14486-7AA5-46D4-8D7F-CE8376DEAE6D}" dt="2020-11-19T11:59:21.773" v="7" actId="478"/>
          <ac:spMkLst>
            <pc:docMk/>
            <pc:sldMk cId="1209583907" sldId="909"/>
            <ac:spMk id="183" creationId="{0D7B230D-37E4-4C28-A0FD-54889FCF87A4}"/>
          </ac:spMkLst>
        </pc:spChg>
        <pc:spChg chg="del">
          <ac:chgData name="Sharon Khuzwayo" userId="508b925d-0867-40ec-8808-4146cd359f6b" providerId="ADAL" clId="{9BC14486-7AA5-46D4-8D7F-CE8376DEAE6D}" dt="2020-11-19T11:59:21.773" v="7" actId="478"/>
          <ac:spMkLst>
            <pc:docMk/>
            <pc:sldMk cId="1209583907" sldId="909"/>
            <ac:spMk id="184" creationId="{3C55FDC0-ED78-4714-8D40-0312383C4D0A}"/>
          </ac:spMkLst>
        </pc:spChg>
        <pc:grpChg chg="add mod">
          <ac:chgData name="Sharon Khuzwayo" userId="508b925d-0867-40ec-8808-4146cd359f6b" providerId="ADAL" clId="{9BC14486-7AA5-46D4-8D7F-CE8376DEAE6D}" dt="2020-11-19T22:17:17.106" v="347" actId="1037"/>
          <ac:grpSpMkLst>
            <pc:docMk/>
            <pc:sldMk cId="1209583907" sldId="909"/>
            <ac:grpSpMk id="6" creationId="{843DC456-94D7-4060-B2A6-7E718DFDAF99}"/>
          </ac:grpSpMkLst>
        </pc:grpChg>
        <pc:grpChg chg="mod">
          <ac:chgData name="Sharon Khuzwayo" userId="508b925d-0867-40ec-8808-4146cd359f6b" providerId="ADAL" clId="{9BC14486-7AA5-46D4-8D7F-CE8376DEAE6D}" dt="2020-11-19T22:16:39.440" v="327"/>
          <ac:grpSpMkLst>
            <pc:docMk/>
            <pc:sldMk cId="1209583907" sldId="909"/>
            <ac:grpSpMk id="8" creationId="{C8876608-E4C6-424C-8D4A-B745BBD95726}"/>
          </ac:grpSpMkLst>
        </pc:grpChg>
        <pc:graphicFrameChg chg="mod">
          <ac:chgData name="Sharon Khuzwayo" userId="508b925d-0867-40ec-8808-4146cd359f6b" providerId="ADAL" clId="{9BC14486-7AA5-46D4-8D7F-CE8376DEAE6D}" dt="2020-11-19T22:16:39.440" v="327"/>
          <ac:graphicFrameMkLst>
            <pc:docMk/>
            <pc:sldMk cId="1209583907" sldId="909"/>
            <ac:graphicFrameMk id="7" creationId="{E1CA6D49-96FE-4344-B7D7-2A8A2C83F70A}"/>
          </ac:graphicFrameMkLst>
        </pc:graphicFrameChg>
        <pc:graphicFrameChg chg="add mod">
          <ac:chgData name="Sharon Khuzwayo" userId="508b925d-0867-40ec-8808-4146cd359f6b" providerId="ADAL" clId="{9BC14486-7AA5-46D4-8D7F-CE8376DEAE6D}" dt="2020-11-19T22:17:11.404" v="346" actId="1038"/>
          <ac:graphicFrameMkLst>
            <pc:docMk/>
            <pc:sldMk cId="1209583907" sldId="909"/>
            <ac:graphicFrameMk id="11" creationId="{CE17C607-DE01-43D4-A402-442D38348492}"/>
          </ac:graphicFrameMkLst>
        </pc:graphicFrameChg>
        <pc:picChg chg="del">
          <ac:chgData name="Sharon Khuzwayo" userId="508b925d-0867-40ec-8808-4146cd359f6b" providerId="ADAL" clId="{9BC14486-7AA5-46D4-8D7F-CE8376DEAE6D}" dt="2020-11-19T11:59:15.897" v="5" actId="478"/>
          <ac:picMkLst>
            <pc:docMk/>
            <pc:sldMk cId="1209583907" sldId="909"/>
            <ac:picMk id="4" creationId="{4286AFC6-FD9B-4C69-BC3B-5E4A739947F1}"/>
          </ac:picMkLst>
        </pc:picChg>
        <pc:picChg chg="del">
          <ac:chgData name="Sharon Khuzwayo" userId="508b925d-0867-40ec-8808-4146cd359f6b" providerId="ADAL" clId="{9BC14486-7AA5-46D4-8D7F-CE8376DEAE6D}" dt="2020-11-19T11:59:15.897" v="5" actId="478"/>
          <ac:picMkLst>
            <pc:docMk/>
            <pc:sldMk cId="1209583907" sldId="909"/>
            <ac:picMk id="7" creationId="{FC77F16E-5F1A-4BDC-98C8-0A7F02221C9E}"/>
          </ac:picMkLst>
        </pc:picChg>
        <pc:picChg chg="del">
          <ac:chgData name="Sharon Khuzwayo" userId="508b925d-0867-40ec-8808-4146cd359f6b" providerId="ADAL" clId="{9BC14486-7AA5-46D4-8D7F-CE8376DEAE6D}" dt="2020-11-19T11:59:21.773" v="7" actId="478"/>
          <ac:picMkLst>
            <pc:docMk/>
            <pc:sldMk cId="1209583907" sldId="909"/>
            <ac:picMk id="13" creationId="{1C8EAEFF-C3A1-4FEE-8775-E622F577E235}"/>
          </ac:picMkLst>
        </pc:picChg>
        <pc:picChg chg="del mod">
          <ac:chgData name="Sharon Khuzwayo" userId="508b925d-0867-40ec-8808-4146cd359f6b" providerId="ADAL" clId="{9BC14486-7AA5-46D4-8D7F-CE8376DEAE6D}" dt="2020-11-19T22:16:57.827" v="331" actId="478"/>
          <ac:picMkLst>
            <pc:docMk/>
            <pc:sldMk cId="1209583907" sldId="909"/>
            <ac:picMk id="17" creationId="{AADC6471-4D67-4FB1-93D6-46BDD89E28BD}"/>
          </ac:picMkLst>
        </pc:picChg>
        <pc:cxnChg chg="mod">
          <ac:chgData name="Sharon Khuzwayo" userId="508b925d-0867-40ec-8808-4146cd359f6b" providerId="ADAL" clId="{9BC14486-7AA5-46D4-8D7F-CE8376DEAE6D}" dt="2020-11-19T22:16:39.440" v="327"/>
          <ac:cxnSpMkLst>
            <pc:docMk/>
            <pc:sldMk cId="1209583907" sldId="909"/>
            <ac:cxnSpMk id="9" creationId="{D3B130E5-7480-4F33-9F2D-36C05483AD15}"/>
          </ac:cxnSpMkLst>
        </pc:cxnChg>
      </pc:sldChg>
      <pc:sldChg chg="addSp delSp modSp add mod">
        <pc:chgData name="Sharon Khuzwayo" userId="508b925d-0867-40ec-8808-4146cd359f6b" providerId="ADAL" clId="{9BC14486-7AA5-46D4-8D7F-CE8376DEAE6D}" dt="2020-11-19T22:19:08.391" v="404" actId="1036"/>
        <pc:sldMkLst>
          <pc:docMk/>
          <pc:sldMk cId="2094621644" sldId="910"/>
        </pc:sldMkLst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2" creationId="{92385024-C22B-4DD4-842F-89AE709F4DDC}"/>
          </ac:spMkLst>
        </pc:spChg>
        <pc:spChg chg="mod">
          <ac:chgData name="Sharon Khuzwayo" userId="508b925d-0867-40ec-8808-4146cd359f6b" providerId="ADAL" clId="{9BC14486-7AA5-46D4-8D7F-CE8376DEAE6D}" dt="2020-11-19T11:59:55.585" v="122" actId="1035"/>
          <ac:spMkLst>
            <pc:docMk/>
            <pc:sldMk cId="2094621644" sldId="910"/>
            <ac:spMk id="3" creationId="{0911E71B-B185-4DB7-BCBF-0ED4364F7251}"/>
          </ac:spMkLst>
        </pc:spChg>
        <pc:spChg chg="mod">
          <ac:chgData name="Sharon Khuzwayo" userId="508b925d-0867-40ec-8808-4146cd359f6b" providerId="ADAL" clId="{9BC14486-7AA5-46D4-8D7F-CE8376DEAE6D}" dt="2020-11-19T15:46:34.594" v="198" actId="1038"/>
          <ac:spMkLst>
            <pc:docMk/>
            <pc:sldMk cId="2094621644" sldId="910"/>
            <ac:spMk id="5" creationId="{F7CB35E9-F7F7-4F91-8376-AFFE0C63D863}"/>
          </ac:spMkLst>
        </pc:spChg>
        <pc:spChg chg="mod">
          <ac:chgData name="Sharon Khuzwayo" userId="508b925d-0867-40ec-8808-4146cd359f6b" providerId="ADAL" clId="{9BC14486-7AA5-46D4-8D7F-CE8376DEAE6D}" dt="2020-11-19T22:19:03.915" v="398" actId="1036"/>
          <ac:spMkLst>
            <pc:docMk/>
            <pc:sldMk cId="2094621644" sldId="910"/>
            <ac:spMk id="6" creationId="{B67C62CE-E81B-4578-A4E5-F6687A125F84}"/>
          </ac:spMkLst>
        </pc:spChg>
        <pc:spChg chg="add mod">
          <ac:chgData name="Sharon Khuzwayo" userId="508b925d-0867-40ec-8808-4146cd359f6b" providerId="ADAL" clId="{9BC14486-7AA5-46D4-8D7F-CE8376DEAE6D}" dt="2020-11-19T22:18:37.627" v="376" actId="164"/>
          <ac:spMkLst>
            <pc:docMk/>
            <pc:sldMk cId="2094621644" sldId="910"/>
            <ac:spMk id="9" creationId="{B3CAA195-0CD3-4C18-9C22-5CD2B66FCD77}"/>
          </ac:spMkLst>
        </pc:spChg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63" creationId="{FB80E37B-2710-4F50-A2CC-5D2A41DAE825}"/>
          </ac:spMkLst>
        </pc:spChg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64" creationId="{7D2344AD-F935-4EF8-AF11-1F0F54F9395E}"/>
          </ac:spMkLst>
        </pc:spChg>
        <pc:spChg chg="del">
          <ac:chgData name="Sharon Khuzwayo" userId="508b925d-0867-40ec-8808-4146cd359f6b" providerId="ADAL" clId="{9BC14486-7AA5-46D4-8D7F-CE8376DEAE6D}" dt="2020-11-19T11:59:46.164" v="48" actId="478"/>
          <ac:spMkLst>
            <pc:docMk/>
            <pc:sldMk cId="2094621644" sldId="910"/>
            <ac:spMk id="73" creationId="{01FE7796-1385-4C24-AFAC-12AFE94103C1}"/>
          </ac:spMkLst>
        </pc:spChg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167" creationId="{A8E1646D-60C7-4ED9-AA2F-71E67001D5A1}"/>
          </ac:spMkLst>
        </pc:spChg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183" creationId="{0D7B230D-37E4-4C28-A0FD-54889FCF87A4}"/>
          </ac:spMkLst>
        </pc:spChg>
        <pc:spChg chg="del">
          <ac:chgData name="Sharon Khuzwayo" userId="508b925d-0867-40ec-8808-4146cd359f6b" providerId="ADAL" clId="{9BC14486-7AA5-46D4-8D7F-CE8376DEAE6D}" dt="2020-11-19T11:59:43.886" v="47" actId="478"/>
          <ac:spMkLst>
            <pc:docMk/>
            <pc:sldMk cId="2094621644" sldId="910"/>
            <ac:spMk id="184" creationId="{3C55FDC0-ED78-4714-8D40-0312383C4D0A}"/>
          </ac:spMkLst>
        </pc:spChg>
        <pc:grpChg chg="add mod">
          <ac:chgData name="Sharon Khuzwayo" userId="508b925d-0867-40ec-8808-4146cd359f6b" providerId="ADAL" clId="{9BC14486-7AA5-46D4-8D7F-CE8376DEAE6D}" dt="2020-11-19T22:19:08.391" v="404" actId="1036"/>
          <ac:grpSpMkLst>
            <pc:docMk/>
            <pc:sldMk cId="2094621644" sldId="910"/>
            <ac:grpSpMk id="2" creationId="{406CB63B-950D-4EF7-8445-B0B3C9668EA8}"/>
          </ac:grpSpMkLst>
        </pc:grpChg>
        <pc:picChg chg="mod">
          <ac:chgData name="Sharon Khuzwayo" userId="508b925d-0867-40ec-8808-4146cd359f6b" providerId="ADAL" clId="{9BC14486-7AA5-46D4-8D7F-CE8376DEAE6D}" dt="2020-11-19T15:46:56.902" v="200" actId="1076"/>
          <ac:picMkLst>
            <pc:docMk/>
            <pc:sldMk cId="2094621644" sldId="910"/>
            <ac:picMk id="4" creationId="{4286AFC6-FD9B-4C69-BC3B-5E4A739947F1}"/>
          </ac:picMkLst>
        </pc:picChg>
        <pc:picChg chg="add mod">
          <ac:chgData name="Sharon Khuzwayo" userId="508b925d-0867-40ec-8808-4146cd359f6b" providerId="ADAL" clId="{9BC14486-7AA5-46D4-8D7F-CE8376DEAE6D}" dt="2020-11-19T22:18:37.627" v="376" actId="164"/>
          <ac:picMkLst>
            <pc:docMk/>
            <pc:sldMk cId="2094621644" sldId="910"/>
            <ac:picMk id="7" creationId="{8E131CE6-012D-4209-BC8A-EBBF7F1A33DC}"/>
          </ac:picMkLst>
        </pc:picChg>
        <pc:picChg chg="del mod">
          <ac:chgData name="Sharon Khuzwayo" userId="508b925d-0867-40ec-8808-4146cd359f6b" providerId="ADAL" clId="{9BC14486-7AA5-46D4-8D7F-CE8376DEAE6D}" dt="2020-11-19T15:46:19.498" v="179" actId="478"/>
          <ac:picMkLst>
            <pc:docMk/>
            <pc:sldMk cId="2094621644" sldId="910"/>
            <ac:picMk id="7" creationId="{FC77F16E-5F1A-4BDC-98C8-0A7F02221C9E}"/>
          </ac:picMkLst>
        </pc:picChg>
        <pc:picChg chg="add del mod">
          <ac:chgData name="Sharon Khuzwayo" userId="508b925d-0867-40ec-8808-4146cd359f6b" providerId="ADAL" clId="{9BC14486-7AA5-46D4-8D7F-CE8376DEAE6D}" dt="2020-11-19T22:18:33.346" v="375" actId="478"/>
          <ac:picMkLst>
            <pc:docMk/>
            <pc:sldMk cId="2094621644" sldId="910"/>
            <ac:picMk id="8" creationId="{EC371BFC-885E-45F4-91CF-0EF1258618E0}"/>
          </ac:picMkLst>
        </pc:picChg>
        <pc:picChg chg="del">
          <ac:chgData name="Sharon Khuzwayo" userId="508b925d-0867-40ec-8808-4146cd359f6b" providerId="ADAL" clId="{9BC14486-7AA5-46D4-8D7F-CE8376DEAE6D}" dt="2020-11-19T11:59:43.886" v="47" actId="478"/>
          <ac:picMkLst>
            <pc:docMk/>
            <pc:sldMk cId="2094621644" sldId="910"/>
            <ac:picMk id="13" creationId="{1C8EAEFF-C3A1-4FEE-8775-E622F577E235}"/>
          </ac:picMkLst>
        </pc:picChg>
        <pc:picChg chg="del">
          <ac:chgData name="Sharon Khuzwayo" userId="508b925d-0867-40ec-8808-4146cd359f6b" providerId="ADAL" clId="{9BC14486-7AA5-46D4-8D7F-CE8376DEAE6D}" dt="2020-11-19T11:59:43.886" v="47" actId="478"/>
          <ac:picMkLst>
            <pc:docMk/>
            <pc:sldMk cId="2094621644" sldId="910"/>
            <ac:picMk id="17" creationId="{AADC6471-4D67-4FB1-93D6-46BDD89E28BD}"/>
          </ac:picMkLst>
        </pc:picChg>
      </pc:sldChg>
      <pc:sldChg chg="addSp delSp modSp add mod">
        <pc:chgData name="Sharon Khuzwayo" userId="508b925d-0867-40ec-8808-4146cd359f6b" providerId="ADAL" clId="{9BC14486-7AA5-46D4-8D7F-CE8376DEAE6D}" dt="2020-11-19T22:21:49.518" v="492" actId="1037"/>
        <pc:sldMkLst>
          <pc:docMk/>
          <pc:sldMk cId="4109350469" sldId="911"/>
        </pc:sldMkLst>
        <pc:spChg chg="del">
          <ac:chgData name="Sharon Khuzwayo" userId="508b925d-0867-40ec-8808-4146cd359f6b" providerId="ADAL" clId="{9BC14486-7AA5-46D4-8D7F-CE8376DEAE6D}" dt="2020-11-19T12:00:09.100" v="125" actId="478"/>
          <ac:spMkLst>
            <pc:docMk/>
            <pc:sldMk cId="4109350469" sldId="911"/>
            <ac:spMk id="5" creationId="{6BB6013E-385B-4387-8B1C-17B90E00441B}"/>
          </ac:spMkLst>
        </pc:spChg>
        <pc:spChg chg="mod">
          <ac:chgData name="Sharon Khuzwayo" userId="508b925d-0867-40ec-8808-4146cd359f6b" providerId="ADAL" clId="{9BC14486-7AA5-46D4-8D7F-CE8376DEAE6D}" dt="2020-11-19T12:00:15.810" v="173" actId="1035"/>
          <ac:spMkLst>
            <pc:docMk/>
            <pc:sldMk cId="4109350469" sldId="911"/>
            <ac:spMk id="11" creationId="{05E72D94-4F57-4C5C-B3B9-B86D2106CD76}"/>
          </ac:spMkLst>
        </pc:spChg>
        <pc:grpChg chg="del">
          <ac:chgData name="Sharon Khuzwayo" userId="508b925d-0867-40ec-8808-4146cd359f6b" providerId="ADAL" clId="{9BC14486-7AA5-46D4-8D7F-CE8376DEAE6D}" dt="2020-11-19T12:00:09.100" v="125" actId="478"/>
          <ac:grpSpMkLst>
            <pc:docMk/>
            <pc:sldMk cId="4109350469" sldId="911"/>
            <ac:grpSpMk id="22" creationId="{19C20ED8-E0C1-4E3E-B24A-14ABE210D99B}"/>
          </ac:grpSpMkLst>
        </pc:grpChg>
        <pc:picChg chg="del mod">
          <ac:chgData name="Sharon Khuzwayo" userId="508b925d-0867-40ec-8808-4146cd359f6b" providerId="ADAL" clId="{9BC14486-7AA5-46D4-8D7F-CE8376DEAE6D}" dt="2020-11-19T22:21:43.901" v="416" actId="478"/>
          <ac:picMkLst>
            <pc:docMk/>
            <pc:sldMk cId="4109350469" sldId="911"/>
            <ac:picMk id="3" creationId="{AF57299C-EA18-44FE-8771-549AEED493A9}"/>
          </ac:picMkLst>
        </pc:picChg>
        <pc:picChg chg="add mod">
          <ac:chgData name="Sharon Khuzwayo" userId="508b925d-0867-40ec-8808-4146cd359f6b" providerId="ADAL" clId="{9BC14486-7AA5-46D4-8D7F-CE8376DEAE6D}" dt="2020-11-19T22:21:49.518" v="492" actId="1037"/>
          <ac:picMkLst>
            <pc:docMk/>
            <pc:sldMk cId="4109350469" sldId="911"/>
            <ac:picMk id="4" creationId="{A4848628-BA64-4497-8BA0-AA1DD189549C}"/>
          </ac:picMkLst>
        </pc:picChg>
      </pc:sldChg>
      <pc:sldMasterChg chg="del delSldLayout">
        <pc:chgData name="Sharon Khuzwayo" userId="508b925d-0867-40ec-8808-4146cd359f6b" providerId="ADAL" clId="{9BC14486-7AA5-46D4-8D7F-CE8376DEAE6D}" dt="2020-11-19T11:58:56.354" v="0" actId="47"/>
        <pc:sldMasterMkLst>
          <pc:docMk/>
          <pc:sldMasterMk cId="2477719776" sldId="2147483708"/>
        </pc:sldMasterMkLst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3130948777" sldId="2147483709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3530048092" sldId="2147483710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4064905437" sldId="2147483711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141406492" sldId="2147483712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2449199103" sldId="2147483713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4204370936" sldId="2147483714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3793013690" sldId="2147483715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617386428" sldId="2147483716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2377346567" sldId="2147483717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3971328935" sldId="2147483718"/>
          </pc:sldLayoutMkLst>
        </pc:sldLayoutChg>
        <pc:sldLayoutChg chg="del">
          <pc:chgData name="Sharon Khuzwayo" userId="508b925d-0867-40ec-8808-4146cd359f6b" providerId="ADAL" clId="{9BC14486-7AA5-46D4-8D7F-CE8376DEAE6D}" dt="2020-11-19T11:58:56.354" v="0" actId="47"/>
          <pc:sldLayoutMkLst>
            <pc:docMk/>
            <pc:sldMasterMk cId="2477719776" sldId="2147483708"/>
            <pc:sldLayoutMk cId="1653854524" sldId="2147483719"/>
          </pc:sldLayoutMkLst>
        </pc:sldLayoutChg>
      </pc:sldMasterChg>
    </pc:docChg>
  </pc:docChgLst>
  <pc:docChgLst>
    <pc:chgData name="Sharon Khuzwayo" userId="508b925d-0867-40ec-8808-4146cd359f6b" providerId="ADAL" clId="{2703238C-B4EE-4FF9-8A92-0104112DBF26}"/>
    <pc:docChg chg="undo redo custSel modSld">
      <pc:chgData name="Sharon Khuzwayo" userId="508b925d-0867-40ec-8808-4146cd359f6b" providerId="ADAL" clId="{2703238C-B4EE-4FF9-8A92-0104112DBF26}" dt="2020-11-18T12:49:28.714" v="362" actId="1038"/>
      <pc:docMkLst>
        <pc:docMk/>
      </pc:docMkLst>
      <pc:sldChg chg="addSp delSp modSp mod">
        <pc:chgData name="Sharon Khuzwayo" userId="508b925d-0867-40ec-8808-4146cd359f6b" providerId="ADAL" clId="{2703238C-B4EE-4FF9-8A92-0104112DBF26}" dt="2020-11-18T11:39:40.531" v="255" actId="478"/>
        <pc:sldMkLst>
          <pc:docMk/>
          <pc:sldMk cId="741587313" sldId="816"/>
        </pc:sldMkLst>
        <pc:spChg chg="mod">
          <ac:chgData name="Sharon Khuzwayo" userId="508b925d-0867-40ec-8808-4146cd359f6b" providerId="ADAL" clId="{2703238C-B4EE-4FF9-8A92-0104112DBF26}" dt="2020-11-17T18:18:09.995" v="6"/>
          <ac:spMkLst>
            <pc:docMk/>
            <pc:sldMk cId="741587313" sldId="816"/>
            <ac:spMk id="11" creationId="{405151C8-6EB3-4BD1-B109-3417B4608E97}"/>
          </ac:spMkLst>
        </pc:spChg>
        <pc:picChg chg="add mod">
          <ac:chgData name="Sharon Khuzwayo" userId="508b925d-0867-40ec-8808-4146cd359f6b" providerId="ADAL" clId="{2703238C-B4EE-4FF9-8A92-0104112DBF26}" dt="2020-11-18T11:39:34.592" v="254" actId="1035"/>
          <ac:picMkLst>
            <pc:docMk/>
            <pc:sldMk cId="741587313" sldId="816"/>
            <ac:picMk id="4" creationId="{31341C36-A28D-481D-ABE6-6C3D3D322664}"/>
          </ac:picMkLst>
        </pc:picChg>
        <pc:picChg chg="del">
          <ac:chgData name="Sharon Khuzwayo" userId="508b925d-0867-40ec-8808-4146cd359f6b" providerId="ADAL" clId="{2703238C-B4EE-4FF9-8A92-0104112DBF26}" dt="2020-11-18T11:38:46.843" v="129" actId="478"/>
          <ac:picMkLst>
            <pc:docMk/>
            <pc:sldMk cId="741587313" sldId="816"/>
            <ac:picMk id="15" creationId="{2BCC38DB-D97A-4917-8749-F938EBEB3218}"/>
          </ac:picMkLst>
        </pc:picChg>
        <pc:cxnChg chg="add del mod">
          <ac:chgData name="Sharon Khuzwayo" userId="508b925d-0867-40ec-8808-4146cd359f6b" providerId="ADAL" clId="{2703238C-B4EE-4FF9-8A92-0104112DBF26}" dt="2020-11-18T11:39:40.531" v="255" actId="478"/>
          <ac:cxnSpMkLst>
            <pc:docMk/>
            <pc:sldMk cId="741587313" sldId="816"/>
            <ac:cxnSpMk id="6" creationId="{8D2CD2A4-B0E1-430A-83B8-F307470AFA14}"/>
          </ac:cxnSpMkLst>
        </pc:cxnChg>
      </pc:sldChg>
      <pc:sldChg chg="modSp mod">
        <pc:chgData name="Sharon Khuzwayo" userId="508b925d-0867-40ec-8808-4146cd359f6b" providerId="ADAL" clId="{2703238C-B4EE-4FF9-8A92-0104112DBF26}" dt="2020-11-17T18:14:51.385" v="4"/>
        <pc:sldMkLst>
          <pc:docMk/>
          <pc:sldMk cId="474877388" sldId="902"/>
        </pc:sldMkLst>
        <pc:spChg chg="mod">
          <ac:chgData name="Sharon Khuzwayo" userId="508b925d-0867-40ec-8808-4146cd359f6b" providerId="ADAL" clId="{2703238C-B4EE-4FF9-8A92-0104112DBF26}" dt="2020-11-17T18:14:51.385" v="4"/>
          <ac:spMkLst>
            <pc:docMk/>
            <pc:sldMk cId="474877388" sldId="902"/>
            <ac:spMk id="39" creationId="{F9ECAF79-7895-4C88-B11C-FBB07ABBDBAB}"/>
          </ac:spMkLst>
        </pc:spChg>
      </pc:sldChg>
      <pc:sldChg chg="addSp delSp modSp mod">
        <pc:chgData name="Sharon Khuzwayo" userId="508b925d-0867-40ec-8808-4146cd359f6b" providerId="ADAL" clId="{2703238C-B4EE-4FF9-8A92-0104112DBF26}" dt="2020-11-18T12:49:28.714" v="362" actId="1038"/>
        <pc:sldMkLst>
          <pc:docMk/>
          <pc:sldMk cId="3006089881" sldId="903"/>
        </pc:sldMkLst>
        <pc:spChg chg="mod">
          <ac:chgData name="Sharon Khuzwayo" userId="508b925d-0867-40ec-8808-4146cd359f6b" providerId="ADAL" clId="{2703238C-B4EE-4FF9-8A92-0104112DBF26}" dt="2020-11-17T18:16:00.676" v="5"/>
          <ac:spMkLst>
            <pc:docMk/>
            <pc:sldMk cId="3006089881" sldId="903"/>
            <ac:spMk id="39" creationId="{F9ECAF79-7895-4C88-B11C-FBB07ABBDBAB}"/>
          </ac:spMkLst>
        </pc:spChg>
        <pc:picChg chg="del">
          <ac:chgData name="Sharon Khuzwayo" userId="508b925d-0867-40ec-8808-4146cd359f6b" providerId="ADAL" clId="{2703238C-B4EE-4FF9-8A92-0104112DBF26}" dt="2020-11-18T12:47:49.146" v="297" actId="478"/>
          <ac:picMkLst>
            <pc:docMk/>
            <pc:sldMk cId="3006089881" sldId="903"/>
            <ac:picMk id="6" creationId="{8938D6BA-BF4E-420D-A4B5-F89298D1B53C}"/>
          </ac:picMkLst>
        </pc:picChg>
        <pc:picChg chg="add mod">
          <ac:chgData name="Sharon Khuzwayo" userId="508b925d-0867-40ec-8808-4146cd359f6b" providerId="ADAL" clId="{2703238C-B4EE-4FF9-8A92-0104112DBF26}" dt="2020-11-18T12:49:28.714" v="362" actId="1038"/>
          <ac:picMkLst>
            <pc:docMk/>
            <pc:sldMk cId="3006089881" sldId="903"/>
            <ac:picMk id="7" creationId="{D9EC052D-5ADD-4308-B348-79D2CDC4EDB1}"/>
          </ac:picMkLst>
        </pc:picChg>
        <pc:picChg chg="del">
          <ac:chgData name="Sharon Khuzwayo" userId="508b925d-0867-40ec-8808-4146cd359f6b" providerId="ADAL" clId="{2703238C-B4EE-4FF9-8A92-0104112DBF26}" dt="2020-11-18T12:48:58.526" v="336" actId="478"/>
          <ac:picMkLst>
            <pc:docMk/>
            <pc:sldMk cId="3006089881" sldId="903"/>
            <ac:picMk id="8" creationId="{EBD7229D-5AAF-4ACB-9119-DBED24B26E4D}"/>
          </ac:picMkLst>
        </pc:picChg>
        <pc:picChg chg="add mod">
          <ac:chgData name="Sharon Khuzwayo" userId="508b925d-0867-40ec-8808-4146cd359f6b" providerId="ADAL" clId="{2703238C-B4EE-4FF9-8A92-0104112DBF26}" dt="2020-11-18T12:49:13.126" v="358" actId="1036"/>
          <ac:picMkLst>
            <pc:docMk/>
            <pc:sldMk cId="3006089881" sldId="903"/>
            <ac:picMk id="10" creationId="{19D4E522-8239-425F-886E-E4EEC1241BE9}"/>
          </ac:picMkLst>
        </pc:picChg>
      </pc:sldChg>
      <pc:sldChg chg="modSp mod">
        <pc:chgData name="Sharon Khuzwayo" userId="508b925d-0867-40ec-8808-4146cd359f6b" providerId="ADAL" clId="{2703238C-B4EE-4FF9-8A92-0104112DBF26}" dt="2020-11-17T18:21:24.567" v="7"/>
        <pc:sldMkLst>
          <pc:docMk/>
          <pc:sldMk cId="452526124" sldId="905"/>
        </pc:sldMkLst>
        <pc:spChg chg="mod">
          <ac:chgData name="Sharon Khuzwayo" userId="508b925d-0867-40ec-8808-4146cd359f6b" providerId="ADAL" clId="{2703238C-B4EE-4FF9-8A92-0104112DBF26}" dt="2020-11-17T18:21:24.567" v="7"/>
          <ac:spMkLst>
            <pc:docMk/>
            <pc:sldMk cId="452526124" sldId="905"/>
            <ac:spMk id="3" creationId="{552ADC5F-12A7-4EDE-A5BF-394750520BDD}"/>
          </ac:spMkLst>
        </pc:spChg>
      </pc:sldChg>
      <pc:sldChg chg="modSp mod">
        <pc:chgData name="Sharon Khuzwayo" userId="508b925d-0867-40ec-8808-4146cd359f6b" providerId="ADAL" clId="{2703238C-B4EE-4FF9-8A92-0104112DBF26}" dt="2020-11-17T18:24:18.780" v="14" actId="20577"/>
        <pc:sldMkLst>
          <pc:docMk/>
          <pc:sldMk cId="229617064" sldId="907"/>
        </pc:sldMkLst>
        <pc:spChg chg="mod">
          <ac:chgData name="Sharon Khuzwayo" userId="508b925d-0867-40ec-8808-4146cd359f6b" providerId="ADAL" clId="{2703238C-B4EE-4FF9-8A92-0104112DBF26}" dt="2020-11-17T18:22:31.952" v="8"/>
          <ac:spMkLst>
            <pc:docMk/>
            <pc:sldMk cId="229617064" sldId="907"/>
            <ac:spMk id="2" creationId="{92385024-C22B-4DD4-842F-89AE709F4DDC}"/>
          </ac:spMkLst>
        </pc:spChg>
        <pc:spChg chg="mod">
          <ac:chgData name="Sharon Khuzwayo" userId="508b925d-0867-40ec-8808-4146cd359f6b" providerId="ADAL" clId="{2703238C-B4EE-4FF9-8A92-0104112DBF26}" dt="2020-11-17T18:24:18.780" v="14" actId="20577"/>
          <ac:spMkLst>
            <pc:docMk/>
            <pc:sldMk cId="229617064" sldId="907"/>
            <ac:spMk id="6" creationId="{B67C62CE-E81B-4578-A4E5-F6687A125F84}"/>
          </ac:spMkLst>
        </pc:spChg>
        <pc:spChg chg="mod">
          <ac:chgData name="Sharon Khuzwayo" userId="508b925d-0867-40ec-8808-4146cd359f6b" providerId="ADAL" clId="{2703238C-B4EE-4FF9-8A92-0104112DBF26}" dt="2020-11-17T18:23:28.008" v="10" actId="20577"/>
          <ac:spMkLst>
            <pc:docMk/>
            <pc:sldMk cId="229617064" sldId="907"/>
            <ac:spMk id="73" creationId="{01FE7796-1385-4C24-AFAC-12AFE94103C1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918D90-B851-4EF1-8CCA-2E161F196DDF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518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036583-33CA-4BE8-A7CA-F1BEB31856E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54976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67166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0444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61860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7632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3864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6865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0891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27174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67785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78264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21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BEF51-8685-46FC-989A-125425DBB6E4}" type="datetimeFigureOut">
              <a:rPr lang="en-ZA" smtClean="0"/>
              <a:t>2020/11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E25CD-BFB0-4B37-9882-8DE7AE133A9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72584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TextBox 166">
            <a:extLst>
              <a:ext uri="{FF2B5EF4-FFF2-40B4-BE49-F238E27FC236}">
                <a16:creationId xmlns:a16="http://schemas.microsoft.com/office/drawing/2014/main" id="{A8E1646D-60C7-4ED9-AA2F-71E67001D5A1}"/>
              </a:ext>
            </a:extLst>
          </p:cNvPr>
          <p:cNvSpPr txBox="1"/>
          <p:nvPr/>
        </p:nvSpPr>
        <p:spPr>
          <a:xfrm>
            <a:off x="188216" y="67572"/>
            <a:ext cx="28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400" b="1" dirty="0"/>
              <a:t>A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0D7B230D-37E4-4C28-A0FD-54889FCF87A4}"/>
              </a:ext>
            </a:extLst>
          </p:cNvPr>
          <p:cNvSpPr txBox="1"/>
          <p:nvPr/>
        </p:nvSpPr>
        <p:spPr>
          <a:xfrm>
            <a:off x="2378268" y="71029"/>
            <a:ext cx="28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400" b="1" dirty="0"/>
              <a:t>B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3C55FDC0-ED78-4714-8D40-0312383C4D0A}"/>
              </a:ext>
            </a:extLst>
          </p:cNvPr>
          <p:cNvSpPr txBox="1"/>
          <p:nvPr/>
        </p:nvSpPr>
        <p:spPr>
          <a:xfrm>
            <a:off x="4547906" y="67572"/>
            <a:ext cx="28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400" b="1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2385024-C22B-4DD4-842F-89AE709F4DDC}"/>
              </a:ext>
            </a:extLst>
          </p:cNvPr>
          <p:cNvSpPr txBox="1"/>
          <p:nvPr/>
        </p:nvSpPr>
        <p:spPr>
          <a:xfrm>
            <a:off x="266700" y="1932827"/>
            <a:ext cx="6324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Figure 1: </a:t>
            </a:r>
            <a:r>
              <a:rPr lang="en-ZA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-inflammatory cytokine and cytolytic molecule production of MR1 tetramer-positive MAIT cells (n = 8) in the peripheral blood (red) and bronchoalveolar lavage (BAL) fluid (blue) in contrast to matched conventional CD8+ T cells (n  = 10) from healthy participants  showing (A) inducible IFN-</a:t>
            </a:r>
            <a:r>
              <a:rPr lang="el-GR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γ, (</a:t>
            </a:r>
            <a:r>
              <a:rPr lang="en-ZA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inducible IL-17 and (C) constitutive granzyme B production. Bars represent medians and error bars represent interquartile ranges. Statistical difference was determined using the Mann-Whitney U test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ZA" sz="800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B0E65DD-3D06-4945-83B0-4700E202A91C}"/>
              </a:ext>
            </a:extLst>
          </p:cNvPr>
          <p:cNvGrpSpPr/>
          <p:nvPr/>
        </p:nvGrpSpPr>
        <p:grpSpPr>
          <a:xfrm>
            <a:off x="154991" y="397092"/>
            <a:ext cx="2230096" cy="1529424"/>
            <a:chOff x="425449" y="641351"/>
            <a:chExt cx="1978025" cy="1331571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51C28E4E-7E2B-4DAE-9E4C-8F900D664BE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7918009"/>
                </p:ext>
              </p:extLst>
            </p:nvPr>
          </p:nvGraphicFramePr>
          <p:xfrm>
            <a:off x="425449" y="641351"/>
            <a:ext cx="1978025" cy="1169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8" r:id="rId3" imgW="4213948" imgH="2486125" progId="Prism8.Document">
                    <p:embed/>
                  </p:oleObj>
                </mc:Choice>
                <mc:Fallback>
                  <p:oleObj name="Prism 8" r:id="rId3" imgW="4213948" imgH="2486125" progId="Prism8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51C28E4E-7E2B-4DAE-9E4C-8F900D664BE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5449" y="641351"/>
                          <a:ext cx="1978025" cy="1169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C54A7BF-7D31-4300-87FA-113A7DBE1360}"/>
                </a:ext>
              </a:extLst>
            </p:cNvPr>
            <p:cNvGrpSpPr/>
            <p:nvPr/>
          </p:nvGrpSpPr>
          <p:grpSpPr>
            <a:xfrm>
              <a:off x="973588" y="671584"/>
              <a:ext cx="1081113" cy="1301338"/>
              <a:chOff x="741151" y="914547"/>
              <a:chExt cx="1330600" cy="1601646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20D556D4-BCBF-4D14-B233-BB5F90DE4DA7}"/>
                  </a:ext>
                </a:extLst>
              </p:cNvPr>
              <p:cNvGrpSpPr/>
              <p:nvPr/>
            </p:nvGrpSpPr>
            <p:grpSpPr>
              <a:xfrm>
                <a:off x="1574856" y="914547"/>
                <a:ext cx="413732" cy="247349"/>
                <a:chOff x="3877069" y="6071437"/>
                <a:chExt cx="413732" cy="247349"/>
              </a:xfrm>
            </p:grpSpPr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B48FBD28-4375-4046-BEFD-E8A7AE70D470}"/>
                    </a:ext>
                  </a:extLst>
                </p:cNvPr>
                <p:cNvSpPr txBox="1"/>
                <p:nvPr/>
              </p:nvSpPr>
              <p:spPr>
                <a:xfrm>
                  <a:off x="3877069" y="6071437"/>
                  <a:ext cx="413732" cy="2473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900" dirty="0"/>
                    <a:t>**</a:t>
                  </a:r>
                </a:p>
              </p:txBody>
            </p: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5BF29CF1-9F47-4CCA-8D39-DF3F1D7533E3}"/>
                    </a:ext>
                  </a:extLst>
                </p:cNvPr>
                <p:cNvCxnSpPr/>
                <p:nvPr/>
              </p:nvCxnSpPr>
              <p:spPr>
                <a:xfrm>
                  <a:off x="3916073" y="6240763"/>
                  <a:ext cx="34035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F5905B0C-DBC7-452A-BB1A-769EB9AF737C}"/>
                  </a:ext>
                </a:extLst>
              </p:cNvPr>
              <p:cNvGrpSpPr/>
              <p:nvPr/>
            </p:nvGrpSpPr>
            <p:grpSpPr>
              <a:xfrm>
                <a:off x="741151" y="2226887"/>
                <a:ext cx="1330600" cy="289306"/>
                <a:chOff x="741151" y="2226887"/>
                <a:chExt cx="1330600" cy="289306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E1530A5-0057-4BE6-A8B4-A0F2A0C0459E}"/>
                    </a:ext>
                  </a:extLst>
                </p:cNvPr>
                <p:cNvSpPr txBox="1"/>
                <p:nvPr/>
              </p:nvSpPr>
              <p:spPr>
                <a:xfrm>
                  <a:off x="764364" y="2280062"/>
                  <a:ext cx="537373" cy="2308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800" dirty="0"/>
                    <a:t>PBMC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7D40BAB3-B111-4894-8F99-3A2B91398F57}"/>
                    </a:ext>
                  </a:extLst>
                </p:cNvPr>
                <p:cNvSpPr txBox="1"/>
                <p:nvPr/>
              </p:nvSpPr>
              <p:spPr>
                <a:xfrm>
                  <a:off x="1538651" y="2285334"/>
                  <a:ext cx="459968" cy="2308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ZA" sz="800" dirty="0"/>
                    <a:t>BAL</a:t>
                  </a:r>
                </a:p>
              </p:txBody>
            </p:sp>
            <p:sp>
              <p:nvSpPr>
                <p:cNvPr id="15" name="Right Bracket 14">
                  <a:extLst>
                    <a:ext uri="{FF2B5EF4-FFF2-40B4-BE49-F238E27FC236}">
                      <a16:creationId xmlns:a16="http://schemas.microsoft.com/office/drawing/2014/main" id="{D28C82F7-A3EE-4685-AA7B-C252E337C452}"/>
                    </a:ext>
                  </a:extLst>
                </p:cNvPr>
                <p:cNvSpPr/>
                <p:nvPr/>
              </p:nvSpPr>
              <p:spPr>
                <a:xfrm rot="5400000">
                  <a:off x="1021614" y="1946424"/>
                  <a:ext cx="41564" cy="602490"/>
                </a:xfrm>
                <a:prstGeom prst="rightBracket">
                  <a:avLst/>
                </a:prstGeom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ZA" sz="900"/>
                </a:p>
              </p:txBody>
            </p:sp>
            <p:sp>
              <p:nvSpPr>
                <p:cNvPr id="16" name="Right Bracket 15">
                  <a:extLst>
                    <a:ext uri="{FF2B5EF4-FFF2-40B4-BE49-F238E27FC236}">
                      <a16:creationId xmlns:a16="http://schemas.microsoft.com/office/drawing/2014/main" id="{291240AC-7CA6-4DE6-B085-0207F4AAE437}"/>
                    </a:ext>
                  </a:extLst>
                </p:cNvPr>
                <p:cNvSpPr/>
                <p:nvPr/>
              </p:nvSpPr>
              <p:spPr>
                <a:xfrm rot="5400000">
                  <a:off x="1749724" y="1947198"/>
                  <a:ext cx="41564" cy="602490"/>
                </a:xfrm>
                <a:prstGeom prst="rightBracket">
                  <a:avLst/>
                </a:prstGeom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ZA" sz="900"/>
                </a:p>
              </p:txBody>
            </p:sp>
          </p:grpSp>
        </p:grp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0EC5B389-4873-47E3-BB00-CBDE03856082}"/>
              </a:ext>
            </a:extLst>
          </p:cNvPr>
          <p:cNvGrpSpPr/>
          <p:nvPr/>
        </p:nvGrpSpPr>
        <p:grpSpPr>
          <a:xfrm>
            <a:off x="2365364" y="348296"/>
            <a:ext cx="2192780" cy="1549122"/>
            <a:chOff x="2409475" y="882597"/>
            <a:chExt cx="2144042" cy="1623212"/>
          </a:xfrm>
        </p:grpSpPr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2D31D465-BEDB-477B-8A0E-0261724BD8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75062908"/>
                </p:ext>
              </p:extLst>
            </p:nvPr>
          </p:nvGraphicFramePr>
          <p:xfrm>
            <a:off x="2409475" y="882597"/>
            <a:ext cx="2144042" cy="14081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8" r:id="rId5" imgW="4119232" imgH="2757241" progId="Prism8.Document">
                    <p:embed/>
                  </p:oleObj>
                </mc:Choice>
                <mc:Fallback>
                  <p:oleObj name="Prism 8" r:id="rId5" imgW="4119232" imgH="2757241" progId="Prism8.Document">
                    <p:embed/>
                    <p:pic>
                      <p:nvPicPr>
                        <p:cNvPr id="20" name="Object 19">
                          <a:extLst>
                            <a:ext uri="{FF2B5EF4-FFF2-40B4-BE49-F238E27FC236}">
                              <a16:creationId xmlns:a16="http://schemas.microsoft.com/office/drawing/2014/main" id="{2D31D465-BEDB-477B-8A0E-0261724BD8A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409475" y="882597"/>
                          <a:ext cx="2144042" cy="14081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3209990-4171-479A-9310-BC44E667CCFD}"/>
                </a:ext>
              </a:extLst>
            </p:cNvPr>
            <p:cNvGrpSpPr/>
            <p:nvPr/>
          </p:nvGrpSpPr>
          <p:grpSpPr>
            <a:xfrm>
              <a:off x="3103464" y="1019460"/>
              <a:ext cx="396318" cy="241872"/>
              <a:chOff x="2462365" y="2703366"/>
              <a:chExt cx="600817" cy="316908"/>
            </a:xfrm>
          </p:grpSpPr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141B033B-A7D4-4BA7-BFF9-FB46E851B2C2}"/>
                  </a:ext>
                </a:extLst>
              </p:cNvPr>
              <p:cNvCxnSpPr/>
              <p:nvPr/>
            </p:nvCxnSpPr>
            <p:spPr>
              <a:xfrm>
                <a:off x="2505994" y="2916446"/>
                <a:ext cx="5159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5430F0E-3B3A-450C-B619-1602604DE194}"/>
                  </a:ext>
                </a:extLst>
              </p:cNvPr>
              <p:cNvSpPr txBox="1"/>
              <p:nvPr/>
            </p:nvSpPr>
            <p:spPr>
              <a:xfrm>
                <a:off x="2462365" y="2703366"/>
                <a:ext cx="600817" cy="3169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900" dirty="0"/>
                  <a:t>*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D81A028-D0DD-455A-945D-7685F1C3EB13}"/>
                </a:ext>
              </a:extLst>
            </p:cNvPr>
            <p:cNvGrpSpPr/>
            <p:nvPr/>
          </p:nvGrpSpPr>
          <p:grpSpPr>
            <a:xfrm>
              <a:off x="2970645" y="2226886"/>
              <a:ext cx="1204766" cy="278923"/>
              <a:chOff x="769920" y="2226886"/>
              <a:chExt cx="1204766" cy="278923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A8B364E-E56B-4A4D-9CF0-E7E67E9BFF08}"/>
                  </a:ext>
                </a:extLst>
              </p:cNvPr>
              <p:cNvSpPr txBox="1"/>
              <p:nvPr/>
            </p:nvSpPr>
            <p:spPr>
              <a:xfrm>
                <a:off x="819678" y="2280061"/>
                <a:ext cx="459968" cy="2257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dirty="0"/>
                  <a:t>PBMC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3E7FBEA-D03E-4F1B-BD39-C56354545105}"/>
                  </a:ext>
                </a:extLst>
              </p:cNvPr>
              <p:cNvSpPr txBox="1"/>
              <p:nvPr/>
            </p:nvSpPr>
            <p:spPr>
              <a:xfrm>
                <a:off x="1476915" y="2278791"/>
                <a:ext cx="459968" cy="2257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dirty="0"/>
                  <a:t>BAL</a:t>
                </a:r>
              </a:p>
            </p:txBody>
          </p:sp>
          <p:sp>
            <p:nvSpPr>
              <p:cNvPr id="25" name="Right Bracket 24">
                <a:extLst>
                  <a:ext uri="{FF2B5EF4-FFF2-40B4-BE49-F238E27FC236}">
                    <a16:creationId xmlns:a16="http://schemas.microsoft.com/office/drawing/2014/main" id="{AA607A4E-6238-4157-A626-CE0C65339AB5}"/>
                  </a:ext>
                </a:extLst>
              </p:cNvPr>
              <p:cNvSpPr/>
              <p:nvPr/>
            </p:nvSpPr>
            <p:spPr>
              <a:xfrm rot="5400000">
                <a:off x="1018957" y="1977849"/>
                <a:ext cx="41564" cy="539638"/>
              </a:xfrm>
              <a:prstGeom prst="righ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ZA" sz="900"/>
              </a:p>
            </p:txBody>
          </p:sp>
          <p:sp>
            <p:nvSpPr>
              <p:cNvPr id="26" name="Right Bracket 25">
                <a:extLst>
                  <a:ext uri="{FF2B5EF4-FFF2-40B4-BE49-F238E27FC236}">
                    <a16:creationId xmlns:a16="http://schemas.microsoft.com/office/drawing/2014/main" id="{A43FABB7-0C25-4059-A88F-28849B3AE71E}"/>
                  </a:ext>
                </a:extLst>
              </p:cNvPr>
              <p:cNvSpPr/>
              <p:nvPr/>
            </p:nvSpPr>
            <p:spPr>
              <a:xfrm rot="5400000">
                <a:off x="1684085" y="1978621"/>
                <a:ext cx="41564" cy="539639"/>
              </a:xfrm>
              <a:prstGeom prst="righ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ZA" sz="900"/>
              </a:p>
            </p:txBody>
          </p:sp>
        </p:grp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12AF552-7AFA-4724-8256-7D52A495B09F}"/>
              </a:ext>
            </a:extLst>
          </p:cNvPr>
          <p:cNvGrpSpPr/>
          <p:nvPr/>
        </p:nvGrpSpPr>
        <p:grpSpPr>
          <a:xfrm>
            <a:off x="4537961" y="377504"/>
            <a:ext cx="2223202" cy="1518702"/>
            <a:chOff x="4571550" y="883555"/>
            <a:chExt cx="2264690" cy="1627366"/>
          </a:xfrm>
        </p:grpSpPr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8FD579FD-99AF-457D-A2A1-D1B06941B4D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61668727"/>
                </p:ext>
              </p:extLst>
            </p:nvPr>
          </p:nvGraphicFramePr>
          <p:xfrm>
            <a:off x="4571550" y="883555"/>
            <a:ext cx="2264690" cy="14028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8" r:id="rId7" imgW="4116351" imgH="2486125" progId="Prism8.Document">
                    <p:embed/>
                  </p:oleObj>
                </mc:Choice>
                <mc:Fallback>
                  <p:oleObj name="Prism 8" r:id="rId7" imgW="4116351" imgH="2486125" progId="Prism8.Document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8FD579FD-99AF-457D-A2A1-D1B06941B4D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571550" y="883555"/>
                          <a:ext cx="2264690" cy="14028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202E996-5BB8-4284-97E1-2BE5240B6C54}"/>
                </a:ext>
              </a:extLst>
            </p:cNvPr>
            <p:cNvGrpSpPr/>
            <p:nvPr/>
          </p:nvGrpSpPr>
          <p:grpSpPr>
            <a:xfrm>
              <a:off x="5188651" y="981892"/>
              <a:ext cx="462420" cy="247348"/>
              <a:chOff x="2177108" y="2637875"/>
              <a:chExt cx="1129552" cy="447820"/>
            </a:xfrm>
          </p:grpSpPr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A5C8E7E8-1494-49AC-B425-505C762298C7}"/>
                  </a:ext>
                </a:extLst>
              </p:cNvPr>
              <p:cNvCxnSpPr/>
              <p:nvPr/>
            </p:nvCxnSpPr>
            <p:spPr>
              <a:xfrm>
                <a:off x="2336414" y="2916446"/>
                <a:ext cx="83098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40C001C-5738-4025-8BB8-405776BC7253}"/>
                  </a:ext>
                </a:extLst>
              </p:cNvPr>
              <p:cNvSpPr txBox="1"/>
              <p:nvPr/>
            </p:nvSpPr>
            <p:spPr>
              <a:xfrm>
                <a:off x="2177108" y="2637875"/>
                <a:ext cx="1129552" cy="4478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900" dirty="0"/>
                  <a:t>****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DF8C09B6-E6D3-4C43-BB99-73EDB4A04745}"/>
                </a:ext>
              </a:extLst>
            </p:cNvPr>
            <p:cNvGrpSpPr/>
            <p:nvPr/>
          </p:nvGrpSpPr>
          <p:grpSpPr>
            <a:xfrm>
              <a:off x="5915465" y="1361578"/>
              <a:ext cx="498124" cy="247348"/>
              <a:chOff x="2044202" y="2745458"/>
              <a:chExt cx="1450903" cy="288752"/>
            </a:xfrm>
          </p:grpSpPr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01F67C57-1E29-49F6-8E13-D4EE6DF178CA}"/>
                  </a:ext>
                </a:extLst>
              </p:cNvPr>
              <p:cNvCxnSpPr/>
              <p:nvPr/>
            </p:nvCxnSpPr>
            <p:spPr>
              <a:xfrm>
                <a:off x="2294865" y="2916446"/>
                <a:ext cx="91408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60FDD08A-3591-4324-858A-122FD019B910}"/>
                  </a:ext>
                </a:extLst>
              </p:cNvPr>
              <p:cNvSpPr txBox="1"/>
              <p:nvPr/>
            </p:nvSpPr>
            <p:spPr>
              <a:xfrm>
                <a:off x="2044202" y="2745458"/>
                <a:ext cx="1450903" cy="2887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900" dirty="0"/>
                  <a:t>****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FF8AD133-7D10-4391-BE5A-0EB96EBF4063}"/>
                </a:ext>
              </a:extLst>
            </p:cNvPr>
            <p:cNvGrpSpPr/>
            <p:nvPr/>
          </p:nvGrpSpPr>
          <p:grpSpPr>
            <a:xfrm>
              <a:off x="5698677" y="913310"/>
              <a:ext cx="613097" cy="247349"/>
              <a:chOff x="2429243" y="2697652"/>
              <a:chExt cx="686766" cy="400569"/>
            </a:xfrm>
          </p:grpSpPr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BA3CA7E3-3B3C-4F88-9817-C3E76D1C1AA8}"/>
                  </a:ext>
                </a:extLst>
              </p:cNvPr>
              <p:cNvCxnSpPr/>
              <p:nvPr/>
            </p:nvCxnSpPr>
            <p:spPr>
              <a:xfrm>
                <a:off x="2429243" y="2948232"/>
                <a:ext cx="68676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2E9EAD00-15E9-4D72-8725-C43F056738FF}"/>
                  </a:ext>
                </a:extLst>
              </p:cNvPr>
              <p:cNvSpPr txBox="1"/>
              <p:nvPr/>
            </p:nvSpPr>
            <p:spPr>
              <a:xfrm>
                <a:off x="2496362" y="2697652"/>
                <a:ext cx="507205" cy="4005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900" dirty="0"/>
                  <a:t>**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05736C24-A75A-4DF4-A881-87D15EE594A8}"/>
                </a:ext>
              </a:extLst>
            </p:cNvPr>
            <p:cNvGrpSpPr/>
            <p:nvPr/>
          </p:nvGrpSpPr>
          <p:grpSpPr>
            <a:xfrm>
              <a:off x="5193220" y="2221615"/>
              <a:ext cx="1256470" cy="289306"/>
              <a:chOff x="761124" y="2226887"/>
              <a:chExt cx="1256470" cy="289306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9BEA359-240E-4A76-BC96-DADE74A1D286}"/>
                  </a:ext>
                </a:extLst>
              </p:cNvPr>
              <p:cNvSpPr txBox="1"/>
              <p:nvPr/>
            </p:nvSpPr>
            <p:spPr>
              <a:xfrm>
                <a:off x="782099" y="2280062"/>
                <a:ext cx="561683" cy="2308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dirty="0"/>
                  <a:t>PBMC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C045564D-C335-40A4-8091-3FAEA32009C2}"/>
                  </a:ext>
                </a:extLst>
              </p:cNvPr>
              <p:cNvSpPr txBox="1"/>
              <p:nvPr/>
            </p:nvSpPr>
            <p:spPr>
              <a:xfrm>
                <a:off x="1519777" y="2285334"/>
                <a:ext cx="459966" cy="2308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800" dirty="0"/>
                  <a:t>BAL</a:t>
                </a:r>
              </a:p>
            </p:txBody>
          </p:sp>
          <p:sp>
            <p:nvSpPr>
              <p:cNvPr id="37" name="Right Bracket 36">
                <a:extLst>
                  <a:ext uri="{FF2B5EF4-FFF2-40B4-BE49-F238E27FC236}">
                    <a16:creationId xmlns:a16="http://schemas.microsoft.com/office/drawing/2014/main" id="{B85755AB-ADD5-41D5-BCC5-2664044EC1A5}"/>
                  </a:ext>
                </a:extLst>
              </p:cNvPr>
              <p:cNvSpPr/>
              <p:nvPr/>
            </p:nvSpPr>
            <p:spPr>
              <a:xfrm rot="5400000">
                <a:off x="1021183" y="1966828"/>
                <a:ext cx="41564" cy="561682"/>
              </a:xfrm>
              <a:prstGeom prst="righ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ZA" sz="900"/>
              </a:p>
            </p:txBody>
          </p:sp>
          <p:sp>
            <p:nvSpPr>
              <p:cNvPr id="38" name="Right Bracket 37">
                <a:extLst>
                  <a:ext uri="{FF2B5EF4-FFF2-40B4-BE49-F238E27FC236}">
                    <a16:creationId xmlns:a16="http://schemas.microsoft.com/office/drawing/2014/main" id="{74BDB472-111C-4F17-AD75-B4D8B3452AE9}"/>
                  </a:ext>
                </a:extLst>
              </p:cNvPr>
              <p:cNvSpPr/>
              <p:nvPr/>
            </p:nvSpPr>
            <p:spPr>
              <a:xfrm rot="5400000">
                <a:off x="1715971" y="1967602"/>
                <a:ext cx="41564" cy="561683"/>
              </a:xfrm>
              <a:prstGeom prst="rightBracket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ZA" sz="9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9617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62">
            <a:extLst>
              <a:ext uri="{FF2B5EF4-FFF2-40B4-BE49-F238E27FC236}">
                <a16:creationId xmlns:a16="http://schemas.microsoft.com/office/drawing/2014/main" id="{FB80E37B-2710-4F50-A2CC-5D2A41DAE825}"/>
              </a:ext>
            </a:extLst>
          </p:cNvPr>
          <p:cNvSpPr txBox="1"/>
          <p:nvPr/>
        </p:nvSpPr>
        <p:spPr>
          <a:xfrm>
            <a:off x="2660945" y="114880"/>
            <a:ext cx="28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400" b="1" dirty="0"/>
              <a:t>B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D2344AD-F935-4EF8-AF11-1F0F54F9395E}"/>
              </a:ext>
            </a:extLst>
          </p:cNvPr>
          <p:cNvSpPr txBox="1"/>
          <p:nvPr/>
        </p:nvSpPr>
        <p:spPr>
          <a:xfrm>
            <a:off x="270766" y="114880"/>
            <a:ext cx="28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ZA" sz="1400" b="1" dirty="0"/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1FE7796-1385-4C24-AFAC-12AFE94103C1}"/>
              </a:ext>
            </a:extLst>
          </p:cNvPr>
          <p:cNvSpPr txBox="1"/>
          <p:nvPr/>
        </p:nvSpPr>
        <p:spPr>
          <a:xfrm>
            <a:off x="266100" y="2004668"/>
            <a:ext cx="6325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Figure 2: </a:t>
            </a:r>
            <a:r>
              <a:rPr lang="en-GB" sz="800" dirty="0"/>
              <a:t>Frequency of PD-1 expressing (A) CD8+ MR1 tetramer positive MAIT cells and (B) CD4-CD8- MR1 tetramer positive MAIT cells from the peripheral blood of HIV-negative and HIV-positive participants. Bars represent medians and error bars represent interquartile ranges. Statistical difference was determined using the Mann-Whitney U test.</a:t>
            </a:r>
            <a:endParaRPr lang="en-ZA" sz="800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43DC456-94D7-4060-B2A6-7E718DFDAF99}"/>
              </a:ext>
            </a:extLst>
          </p:cNvPr>
          <p:cNvGrpSpPr/>
          <p:nvPr/>
        </p:nvGrpSpPr>
        <p:grpSpPr>
          <a:xfrm>
            <a:off x="260784" y="415569"/>
            <a:ext cx="2384756" cy="1584000"/>
            <a:chOff x="641985" y="9624901"/>
            <a:chExt cx="2709212" cy="1896025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E1CA6D49-96FE-4344-B7D7-2A8A2C83F7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5421512"/>
                </p:ext>
              </p:extLst>
            </p:nvPr>
          </p:nvGraphicFramePr>
          <p:xfrm>
            <a:off x="641985" y="9624901"/>
            <a:ext cx="2709212" cy="18960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0" name="Prism 8" r:id="rId3" imgW="4140840" imgH="2901980" progId="Prism8.Document">
                    <p:embed/>
                  </p:oleObj>
                </mc:Choice>
                <mc:Fallback>
                  <p:oleObj name="Prism 8" r:id="rId3" imgW="4140840" imgH="2901980" progId="Prism8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E1CA6D49-96FE-4344-B7D7-2A8A2C83F7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41985" y="9624901"/>
                          <a:ext cx="2709212" cy="18960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C8876608-E4C6-424C-8D4A-B745BBD95726}"/>
                </a:ext>
              </a:extLst>
            </p:cNvPr>
            <p:cNvGrpSpPr/>
            <p:nvPr/>
          </p:nvGrpSpPr>
          <p:grpSpPr>
            <a:xfrm>
              <a:off x="1855495" y="9759788"/>
              <a:ext cx="607811" cy="323628"/>
              <a:chOff x="1954307" y="2550966"/>
              <a:chExt cx="1619359" cy="494535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D3B130E5-7480-4F33-9F2D-36C05483AD15}"/>
                  </a:ext>
                </a:extLst>
              </p:cNvPr>
              <p:cNvCxnSpPr/>
              <p:nvPr/>
            </p:nvCxnSpPr>
            <p:spPr>
              <a:xfrm>
                <a:off x="1954307" y="2871110"/>
                <a:ext cx="161935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D009423-8070-49B2-BFA2-32A1F5483A9C}"/>
                  </a:ext>
                </a:extLst>
              </p:cNvPr>
              <p:cNvSpPr txBox="1"/>
              <p:nvPr/>
            </p:nvSpPr>
            <p:spPr>
              <a:xfrm>
                <a:off x="2173479" y="2550966"/>
                <a:ext cx="1216649" cy="4945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sz="900" dirty="0"/>
                  <a:t>**</a:t>
                </a:r>
              </a:p>
            </p:txBody>
          </p:sp>
        </p:grpSp>
      </p:grp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E17C607-DE01-43D4-A402-442D383484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5907311"/>
              </p:ext>
            </p:extLst>
          </p:nvPr>
        </p:nvGraphicFramePr>
        <p:xfrm>
          <a:off x="2634497" y="422657"/>
          <a:ext cx="2471658" cy="16008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5" imgW="4140840" imgH="2737438" progId="Prism8.Document">
                  <p:embed/>
                </p:oleObj>
              </mc:Choice>
              <mc:Fallback>
                <p:oleObj name="Prism 8" r:id="rId5" imgW="4140840" imgH="2737438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CE17C607-DE01-43D4-A402-442D383484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34497" y="422657"/>
                        <a:ext cx="2471658" cy="16008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09583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911E71B-B185-4DB7-BCBF-0ED4364F7251}"/>
              </a:ext>
            </a:extLst>
          </p:cNvPr>
          <p:cNvSpPr txBox="1"/>
          <p:nvPr/>
        </p:nvSpPr>
        <p:spPr>
          <a:xfrm>
            <a:off x="266100" y="72573"/>
            <a:ext cx="318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b="1" dirty="0"/>
              <a:t>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86AFC6-FD9B-4C69-BC3B-5E4A73994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285" y="511621"/>
            <a:ext cx="2351330" cy="11452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7CB35E9-F7F7-4F91-8376-AFFE0C63D863}"/>
              </a:ext>
            </a:extLst>
          </p:cNvPr>
          <p:cNvSpPr txBox="1"/>
          <p:nvPr/>
        </p:nvSpPr>
        <p:spPr>
          <a:xfrm>
            <a:off x="2966493" y="69333"/>
            <a:ext cx="318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400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7C62CE-E81B-4578-A4E5-F6687A125F84}"/>
              </a:ext>
            </a:extLst>
          </p:cNvPr>
          <p:cNvSpPr txBox="1"/>
          <p:nvPr/>
        </p:nvSpPr>
        <p:spPr>
          <a:xfrm>
            <a:off x="266399" y="2090133"/>
            <a:ext cx="6325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Figure 3:</a:t>
            </a:r>
            <a:r>
              <a:rPr lang="en-ZA" sz="800" dirty="0"/>
              <a:t> (</a:t>
            </a:r>
            <a:r>
              <a:rPr lang="en-GB" sz="800" dirty="0"/>
              <a:t>A) Summary of characteristics of MR1 tetramer positive MAIT cell transcriptomic clusters. (B) UMAP plot showing assignment of HIV status to MAIT cell transcriptomic subsets.</a:t>
            </a:r>
            <a:endParaRPr lang="en-ZA" sz="8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06CB63B-950D-4EF7-8445-B0B3C9668EA8}"/>
              </a:ext>
            </a:extLst>
          </p:cNvPr>
          <p:cNvGrpSpPr/>
          <p:nvPr/>
        </p:nvGrpSpPr>
        <p:grpSpPr>
          <a:xfrm>
            <a:off x="3572838" y="221534"/>
            <a:ext cx="2368210" cy="1789200"/>
            <a:chOff x="3285164" y="1590373"/>
            <a:chExt cx="2368210" cy="17892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E131CE6-012D-4209-BC8A-EBBF7F1A33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6073"/>
            <a:stretch/>
          </p:blipFill>
          <p:spPr>
            <a:xfrm>
              <a:off x="3285164" y="1590373"/>
              <a:ext cx="2071856" cy="17892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3CAA195-0CD3-4C18-9C22-5CD2B66FCD77}"/>
                </a:ext>
              </a:extLst>
            </p:cNvPr>
            <p:cNvSpPr txBox="1"/>
            <p:nvPr/>
          </p:nvSpPr>
          <p:spPr>
            <a:xfrm>
              <a:off x="5281853" y="2330465"/>
              <a:ext cx="371521" cy="220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540"/>
                </a:lnSpc>
              </a:pPr>
              <a:r>
                <a:rPr lang="en-ZA" sz="450" dirty="0"/>
                <a:t>HIV-</a:t>
              </a:r>
            </a:p>
            <a:p>
              <a:pPr>
                <a:lnSpc>
                  <a:spcPts val="540"/>
                </a:lnSpc>
              </a:pPr>
              <a:r>
                <a:rPr lang="en-ZA" sz="450" dirty="0"/>
                <a:t>HIV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946216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19C20ED8-E0C1-4E3E-B24A-14ABE210D99B}"/>
              </a:ext>
            </a:extLst>
          </p:cNvPr>
          <p:cNvGrpSpPr/>
          <p:nvPr/>
        </p:nvGrpSpPr>
        <p:grpSpPr>
          <a:xfrm>
            <a:off x="358844" y="212386"/>
            <a:ext cx="3514655" cy="1927951"/>
            <a:chOff x="3018162" y="2304771"/>
            <a:chExt cx="3488289" cy="2014774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A774809-2650-4913-80F7-E13848D76C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18162" y="2484288"/>
              <a:ext cx="3488289" cy="1835257"/>
            </a:xfrm>
            <a:prstGeom prst="rect">
              <a:avLst/>
            </a:prstGeom>
          </p:spPr>
        </p:pic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42470182-F253-47D8-9510-026E5A9EC03B}"/>
                </a:ext>
              </a:extLst>
            </p:cNvPr>
            <p:cNvCxnSpPr>
              <a:cxnSpLocks/>
            </p:cNvCxnSpPr>
            <p:nvPr/>
          </p:nvCxnSpPr>
          <p:spPr>
            <a:xfrm>
              <a:off x="4215042" y="2537825"/>
              <a:ext cx="0" cy="1450800"/>
            </a:xfrm>
            <a:prstGeom prst="line">
              <a:avLst/>
            </a:prstGeom>
            <a:ln w="9525">
              <a:solidFill>
                <a:schemeClr val="tx1">
                  <a:lumMod val="85000"/>
                  <a:lumOff val="1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8213B55-6ACC-40CF-B345-5256F7F08C0E}"/>
                </a:ext>
              </a:extLst>
            </p:cNvPr>
            <p:cNvSpPr txBox="1"/>
            <p:nvPr/>
          </p:nvSpPr>
          <p:spPr>
            <a:xfrm>
              <a:off x="3476675" y="2304771"/>
              <a:ext cx="6258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800" b="1" dirty="0"/>
                <a:t>HIV-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5909EBE-5FF1-41BA-B859-F46EE6BC2CF7}"/>
                </a:ext>
              </a:extLst>
            </p:cNvPr>
            <p:cNvSpPr txBox="1"/>
            <p:nvPr/>
          </p:nvSpPr>
          <p:spPr>
            <a:xfrm>
              <a:off x="4322618" y="2304771"/>
              <a:ext cx="1396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ZA" sz="800" b="1" dirty="0"/>
                <a:t>HIV+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BB6013E-385B-4387-8B1C-17B90E00441B}"/>
              </a:ext>
            </a:extLst>
          </p:cNvPr>
          <p:cNvSpPr txBox="1"/>
          <p:nvPr/>
        </p:nvSpPr>
        <p:spPr>
          <a:xfrm>
            <a:off x="294525" y="2203837"/>
            <a:ext cx="6325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Figure 4:</a:t>
            </a:r>
            <a:r>
              <a:rPr lang="en-ZA" sz="800" dirty="0"/>
              <a:t> </a:t>
            </a:r>
            <a:r>
              <a:rPr lang="en-ZA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 distribution of MAIT cell transcriptomic subsets by each participant identifier (PID).</a:t>
            </a:r>
            <a:endParaRPr lang="en-ZA" sz="800" dirty="0"/>
          </a:p>
        </p:txBody>
      </p:sp>
    </p:spTree>
    <p:extLst>
      <p:ext uri="{BB962C8B-B14F-4D97-AF65-F5344CB8AC3E}">
        <p14:creationId xmlns:p14="http://schemas.microsoft.com/office/powerpoint/2010/main" val="2812554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5E72D94-4F57-4C5C-B3B9-B86D2106CD76}"/>
              </a:ext>
            </a:extLst>
          </p:cNvPr>
          <p:cNvSpPr txBox="1"/>
          <p:nvPr/>
        </p:nvSpPr>
        <p:spPr>
          <a:xfrm>
            <a:off x="294525" y="3828280"/>
            <a:ext cx="6172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800" b="1" dirty="0"/>
              <a:t>Supplementary Figure 5:</a:t>
            </a:r>
            <a:r>
              <a:rPr lang="en-ZA" sz="800" dirty="0"/>
              <a:t> </a:t>
            </a:r>
            <a:r>
              <a:rPr lang="en-GB" sz="800" dirty="0"/>
              <a:t>Heatmap showing the expression of signature macrophage genes across the four transcriptional MAIT cell subsets. </a:t>
            </a:r>
            <a:endParaRPr lang="en-ZA" sz="8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4848628-BA64-4497-8BA0-AA1DD18954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439" y="227509"/>
            <a:ext cx="2779914" cy="3503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9350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EB3A17B727F9145AA36BF5F32B1B76E" ma:contentTypeVersion="9" ma:contentTypeDescription="Create a new document." ma:contentTypeScope="" ma:versionID="15cb6ee6e157dfc9010f995d6536ed46">
  <xsd:schema xmlns:xsd="http://www.w3.org/2001/XMLSchema" xmlns:xs="http://www.w3.org/2001/XMLSchema" xmlns:p="http://schemas.microsoft.com/office/2006/metadata/properties" xmlns:ns3="132c664a-40da-43ef-ba59-381b53d0c3d0" targetNamespace="http://schemas.microsoft.com/office/2006/metadata/properties" ma:root="true" ma:fieldsID="9c7b6666f1c6d4f114ea3eb931f0a101" ns3:_="">
    <xsd:import namespace="132c664a-40da-43ef-ba59-381b53d0c3d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2c664a-40da-43ef-ba59-381b53d0c3d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243465A-5C1E-44BD-86F0-66F547A593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2c664a-40da-43ef-ba59-381b53d0c3d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9FAB4BC-AED4-47A0-B5B2-23F963A0B8B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DD00817-05C6-4272-8A06-2F1D7352F281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531</TotalTime>
  <Words>252</Words>
  <Application>Microsoft Office PowerPoint</Application>
  <PresentationFormat>A4 Paper (210x297 mm)</PresentationFormat>
  <Paragraphs>28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ron Khuzwayo</dc:creator>
  <cp:lastModifiedBy>Sharon Khuzwayo</cp:lastModifiedBy>
  <cp:revision>55</cp:revision>
  <dcterms:created xsi:type="dcterms:W3CDTF">2020-01-14T10:09:08Z</dcterms:created>
  <dcterms:modified xsi:type="dcterms:W3CDTF">2020-11-19T22:25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EB3A17B727F9145AA36BF5F32B1B76E</vt:lpwstr>
  </property>
</Properties>
</file>